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drawings/drawing1.xml" ContentType="application/vnd.openxmlformats-officedocument.drawingml.chartshapes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  <p:sldId id="256" r:id="rId5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30" d="100"/>
          <a:sy n="130" d="100"/>
        </p:scale>
        <p:origin x="-104" y="-15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interSettings" Target="printerSettings/printerSettings1.bin"/><Relationship Id="rId7" Type="http://schemas.openxmlformats.org/officeDocument/2006/relationships/presProps" Target="presProps.xml"/><Relationship Id="rId8" Type="http://schemas.openxmlformats.org/officeDocument/2006/relationships/viewProps" Target="viewProps.xml"/><Relationship Id="rId9" Type="http://schemas.openxmlformats.org/officeDocument/2006/relationships/theme" Target="theme/theme1.xml"/><Relationship Id="rId1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Projets:Projets%20EL:Archives:Projet%20SEDENT:protocole-suivi-sacrifice:SEDENT%202&#232;mepartie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Projets:Projets%20EL:Archives:Projet%20SEDENT:protocole-suivi-sacrifice:SEDENT%202&#232;mepartie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Projets:Projets%20EL:Archives:Projet%20SEDENT:protocole-suivi-sacrifice:SEDENT%202&#232;mepartie.xls" TargetMode="External"/><Relationship Id="rId2" Type="http://schemas.openxmlformats.org/officeDocument/2006/relationships/chartUserShapes" Target="../drawings/drawing1.xm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Projets:Projets%20EL:ARTICLES%20SREBP:miR%20CG:Physiol%20Reports:Data%20mir%20Muscle%20LIPOX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2250691070531"/>
          <c:y val="0.115492764846373"/>
          <c:w val="0.795558200775853"/>
          <c:h val="0.721044818185067"/>
        </c:manualLayout>
      </c:layout>
      <c:lineChart>
        <c:grouping val="standard"/>
        <c:varyColors val="0"/>
        <c:ser>
          <c:idx val="0"/>
          <c:order val="0"/>
          <c:tx>
            <c:v>SED</c:v>
          </c:tx>
          <c:spPr>
            <a:ln w="19050">
              <a:solidFill>
                <a:schemeClr val="tx1"/>
              </a:solidFill>
              <a:prstDash val="solid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oids!$G$80:$G$95</c:f>
                <c:numCache>
                  <c:formatCode>General</c:formatCode>
                  <c:ptCount val="16"/>
                  <c:pt idx="0">
                    <c:v>0.30267327452405</c:v>
                  </c:pt>
                  <c:pt idx="1">
                    <c:v>0.443361527925512</c:v>
                  </c:pt>
                  <c:pt idx="2">
                    <c:v>0.481216629434649</c:v>
                  </c:pt>
                  <c:pt idx="3">
                    <c:v>0.489557623438413</c:v>
                  </c:pt>
                  <c:pt idx="4">
                    <c:v>0.611066917593955</c:v>
                  </c:pt>
                  <c:pt idx="5">
                    <c:v>0.493865141286341</c:v>
                  </c:pt>
                  <c:pt idx="6">
                    <c:v>0.648074069840786</c:v>
                  </c:pt>
                  <c:pt idx="7">
                    <c:v>0.554677083235523</c:v>
                  </c:pt>
                  <c:pt idx="8">
                    <c:v>0.498232988782468</c:v>
                  </c:pt>
                  <c:pt idx="9">
                    <c:v>0.662947961758689</c:v>
                  </c:pt>
                  <c:pt idx="10">
                    <c:v>0.606446846622008</c:v>
                  </c:pt>
                  <c:pt idx="11">
                    <c:v>0.661689756104274</c:v>
                  </c:pt>
                  <c:pt idx="12">
                    <c:v>0.636754890144911</c:v>
                  </c:pt>
                  <c:pt idx="13">
                    <c:v>0.481663783151692</c:v>
                  </c:pt>
                  <c:pt idx="14">
                    <c:v>0.63039890369335</c:v>
                  </c:pt>
                  <c:pt idx="15">
                    <c:v>0.694341914653324</c:v>
                  </c:pt>
                </c:numCache>
              </c:numRef>
            </c:plus>
            <c:minus>
              <c:numRef>
                <c:f>Poids!$G$80:$G$95</c:f>
                <c:numCache>
                  <c:formatCode>General</c:formatCode>
                  <c:ptCount val="16"/>
                  <c:pt idx="0">
                    <c:v>0.30267327452405</c:v>
                  </c:pt>
                  <c:pt idx="1">
                    <c:v>0.443361527925512</c:v>
                  </c:pt>
                  <c:pt idx="2">
                    <c:v>0.481216629434649</c:v>
                  </c:pt>
                  <c:pt idx="3">
                    <c:v>0.489557623438413</c:v>
                  </c:pt>
                  <c:pt idx="4">
                    <c:v>0.611066917593955</c:v>
                  </c:pt>
                  <c:pt idx="5">
                    <c:v>0.493865141286341</c:v>
                  </c:pt>
                  <c:pt idx="6">
                    <c:v>0.648074069840786</c:v>
                  </c:pt>
                  <c:pt idx="7">
                    <c:v>0.554677083235523</c:v>
                  </c:pt>
                  <c:pt idx="8">
                    <c:v>0.498232988782468</c:v>
                  </c:pt>
                  <c:pt idx="9">
                    <c:v>0.662947961758689</c:v>
                  </c:pt>
                  <c:pt idx="10">
                    <c:v>0.606446846622008</c:v>
                  </c:pt>
                  <c:pt idx="11">
                    <c:v>0.661689756104274</c:v>
                  </c:pt>
                  <c:pt idx="12">
                    <c:v>0.636754890144911</c:v>
                  </c:pt>
                  <c:pt idx="13">
                    <c:v>0.481663783151692</c:v>
                  </c:pt>
                  <c:pt idx="14">
                    <c:v>0.63039890369335</c:v>
                  </c:pt>
                  <c:pt idx="15">
                    <c:v>0.694341914653324</c:v>
                  </c:pt>
                </c:numCache>
              </c:numRef>
            </c:minus>
            <c:spPr>
              <a:ln w="3175">
                <a:solidFill>
                  <a:schemeClr val="tx1"/>
                </a:solidFill>
                <a:prstDash val="solid"/>
              </a:ln>
            </c:spPr>
          </c:errBars>
          <c:cat>
            <c:numRef>
              <c:f>Poids!$C$83:$C$95</c:f>
              <c:numCache>
                <c:formatCode>General</c:formatCode>
                <c:ptCount val="13"/>
                <c:pt idx="0">
                  <c:v>10.0</c:v>
                </c:pt>
                <c:pt idx="1">
                  <c:v>11.0</c:v>
                </c:pt>
                <c:pt idx="2">
                  <c:v>12.0</c:v>
                </c:pt>
                <c:pt idx="3">
                  <c:v>13.0</c:v>
                </c:pt>
                <c:pt idx="4">
                  <c:v>14.0</c:v>
                </c:pt>
                <c:pt idx="5">
                  <c:v>15.0</c:v>
                </c:pt>
                <c:pt idx="6">
                  <c:v>16.0</c:v>
                </c:pt>
                <c:pt idx="7">
                  <c:v>17.0</c:v>
                </c:pt>
                <c:pt idx="8">
                  <c:v>18.0</c:v>
                </c:pt>
                <c:pt idx="9">
                  <c:v>19.0</c:v>
                </c:pt>
                <c:pt idx="10">
                  <c:v>20.0</c:v>
                </c:pt>
                <c:pt idx="11">
                  <c:v>21.0</c:v>
                </c:pt>
                <c:pt idx="12">
                  <c:v>22.0</c:v>
                </c:pt>
              </c:numCache>
            </c:numRef>
          </c:cat>
          <c:val>
            <c:numRef>
              <c:f>Poids!$E$83:$E$95</c:f>
              <c:numCache>
                <c:formatCode>General</c:formatCode>
                <c:ptCount val="13"/>
                <c:pt idx="0">
                  <c:v>24.7</c:v>
                </c:pt>
                <c:pt idx="1">
                  <c:v>24.85833333333332</c:v>
                </c:pt>
                <c:pt idx="2">
                  <c:v>25.04166666666667</c:v>
                </c:pt>
                <c:pt idx="3">
                  <c:v>25.59999999999999</c:v>
                </c:pt>
                <c:pt idx="4">
                  <c:v>26.1</c:v>
                </c:pt>
                <c:pt idx="5">
                  <c:v>26.39166666666667</c:v>
                </c:pt>
                <c:pt idx="6">
                  <c:v>27.0</c:v>
                </c:pt>
                <c:pt idx="7">
                  <c:v>27.46666666666666</c:v>
                </c:pt>
                <c:pt idx="8">
                  <c:v>26.95</c:v>
                </c:pt>
                <c:pt idx="9">
                  <c:v>27.98888888888888</c:v>
                </c:pt>
                <c:pt idx="10">
                  <c:v>28.1</c:v>
                </c:pt>
                <c:pt idx="11">
                  <c:v>28.69166666666667</c:v>
                </c:pt>
                <c:pt idx="12">
                  <c:v>28.7</c:v>
                </c:pt>
              </c:numCache>
            </c:numRef>
          </c:val>
          <c:smooth val="0"/>
        </c:ser>
        <c:ser>
          <c:idx val="1"/>
          <c:order val="1"/>
          <c:tx>
            <c:v>EX</c:v>
          </c:tx>
          <c:spPr>
            <a:ln w="19050">
              <a:solidFill>
                <a:schemeClr val="tx1"/>
              </a:solidFill>
              <a:prstDash val="sysDash"/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oids!$J$80:$J$95</c:f>
                <c:numCache>
                  <c:formatCode>General</c:formatCode>
                  <c:ptCount val="16"/>
                  <c:pt idx="0">
                    <c:v>0.403387020658045</c:v>
                  </c:pt>
                  <c:pt idx="1">
                    <c:v>0.454007102344877</c:v>
                  </c:pt>
                  <c:pt idx="2">
                    <c:v>0.662465504171868</c:v>
                  </c:pt>
                  <c:pt idx="3">
                    <c:v>0.610564587612366</c:v>
                  </c:pt>
                  <c:pt idx="4">
                    <c:v>0.578762461113847</c:v>
                  </c:pt>
                  <c:pt idx="5">
                    <c:v>0.525748575486277</c:v>
                  </c:pt>
                  <c:pt idx="6">
                    <c:v>0.526427440717272</c:v>
                  </c:pt>
                  <c:pt idx="7">
                    <c:v>0.553974507628321</c:v>
                  </c:pt>
                  <c:pt idx="8">
                    <c:v>0.553344807683669</c:v>
                  </c:pt>
                  <c:pt idx="9">
                    <c:v>0.615944603923145</c:v>
                  </c:pt>
                  <c:pt idx="10">
                    <c:v>0.700291484501494</c:v>
                  </c:pt>
                  <c:pt idx="11">
                    <c:v>0.815245883362888</c:v>
                  </c:pt>
                  <c:pt idx="12">
                    <c:v>0.625026076553516</c:v>
                  </c:pt>
                  <c:pt idx="13">
                    <c:v>0.690558287401809</c:v>
                  </c:pt>
                  <c:pt idx="14">
                    <c:v>0.69066910277195</c:v>
                  </c:pt>
                  <c:pt idx="15">
                    <c:v>0.44138137365186</c:v>
                  </c:pt>
                </c:numCache>
              </c:numRef>
            </c:plus>
            <c:minus>
              <c:numRef>
                <c:f>Poids!$J$80:$J$95</c:f>
                <c:numCache>
                  <c:formatCode>General</c:formatCode>
                  <c:ptCount val="16"/>
                  <c:pt idx="0">
                    <c:v>0.403387020658045</c:v>
                  </c:pt>
                  <c:pt idx="1">
                    <c:v>0.454007102344877</c:v>
                  </c:pt>
                  <c:pt idx="2">
                    <c:v>0.662465504171868</c:v>
                  </c:pt>
                  <c:pt idx="3">
                    <c:v>0.610564587612366</c:v>
                  </c:pt>
                  <c:pt idx="4">
                    <c:v>0.578762461113847</c:v>
                  </c:pt>
                  <c:pt idx="5">
                    <c:v>0.525748575486277</c:v>
                  </c:pt>
                  <c:pt idx="6">
                    <c:v>0.526427440717272</c:v>
                  </c:pt>
                  <c:pt idx="7">
                    <c:v>0.553974507628321</c:v>
                  </c:pt>
                  <c:pt idx="8">
                    <c:v>0.553344807683669</c:v>
                  </c:pt>
                  <c:pt idx="9">
                    <c:v>0.615944603923145</c:v>
                  </c:pt>
                  <c:pt idx="10">
                    <c:v>0.700291484501494</c:v>
                  </c:pt>
                  <c:pt idx="11">
                    <c:v>0.815245883362888</c:v>
                  </c:pt>
                  <c:pt idx="12">
                    <c:v>0.625026076553516</c:v>
                  </c:pt>
                  <c:pt idx="13">
                    <c:v>0.690558287401809</c:v>
                  </c:pt>
                  <c:pt idx="14">
                    <c:v>0.69066910277195</c:v>
                  </c:pt>
                  <c:pt idx="15">
                    <c:v>0.44138137365186</c:v>
                  </c:pt>
                </c:numCache>
              </c:numRef>
            </c:minus>
            <c:spPr>
              <a:ln w="3175">
                <a:solidFill>
                  <a:schemeClr val="tx1"/>
                </a:solidFill>
                <a:prstDash val="solid"/>
              </a:ln>
            </c:spPr>
          </c:errBars>
          <c:cat>
            <c:numRef>
              <c:f>Poids!$C$83:$C$95</c:f>
              <c:numCache>
                <c:formatCode>General</c:formatCode>
                <c:ptCount val="13"/>
                <c:pt idx="0">
                  <c:v>10.0</c:v>
                </c:pt>
                <c:pt idx="1">
                  <c:v>11.0</c:v>
                </c:pt>
                <c:pt idx="2">
                  <c:v>12.0</c:v>
                </c:pt>
                <c:pt idx="3">
                  <c:v>13.0</c:v>
                </c:pt>
                <c:pt idx="4">
                  <c:v>14.0</c:v>
                </c:pt>
                <c:pt idx="5">
                  <c:v>15.0</c:v>
                </c:pt>
                <c:pt idx="6">
                  <c:v>16.0</c:v>
                </c:pt>
                <c:pt idx="7">
                  <c:v>17.0</c:v>
                </c:pt>
                <c:pt idx="8">
                  <c:v>18.0</c:v>
                </c:pt>
                <c:pt idx="9">
                  <c:v>19.0</c:v>
                </c:pt>
                <c:pt idx="10">
                  <c:v>20.0</c:v>
                </c:pt>
                <c:pt idx="11">
                  <c:v>21.0</c:v>
                </c:pt>
                <c:pt idx="12">
                  <c:v>22.0</c:v>
                </c:pt>
              </c:numCache>
            </c:numRef>
          </c:cat>
          <c:val>
            <c:numRef>
              <c:f>Poids!$H$83:$H$95</c:f>
              <c:numCache>
                <c:formatCode>General</c:formatCode>
                <c:ptCount val="13"/>
                <c:pt idx="0">
                  <c:v>25.14285714285714</c:v>
                </c:pt>
                <c:pt idx="1">
                  <c:v>24.98571428571428</c:v>
                </c:pt>
                <c:pt idx="2">
                  <c:v>25.42857142857143</c:v>
                </c:pt>
                <c:pt idx="3">
                  <c:v>25.82142857142857</c:v>
                </c:pt>
                <c:pt idx="4">
                  <c:v>26.42857142857143</c:v>
                </c:pt>
                <c:pt idx="5">
                  <c:v>27.05</c:v>
                </c:pt>
                <c:pt idx="6">
                  <c:v>26.92857142857143</c:v>
                </c:pt>
                <c:pt idx="7">
                  <c:v>27.65714285714286</c:v>
                </c:pt>
                <c:pt idx="8">
                  <c:v>26.92857142857143</c:v>
                </c:pt>
                <c:pt idx="9">
                  <c:v>28.07142857142857</c:v>
                </c:pt>
                <c:pt idx="10">
                  <c:v>28.58571428571428</c:v>
                </c:pt>
                <c:pt idx="11">
                  <c:v>28.75</c:v>
                </c:pt>
                <c:pt idx="12">
                  <c:v>29.0</c:v>
                </c:pt>
              </c:numCache>
            </c:numRef>
          </c:val>
          <c:smooth val="0"/>
        </c:ser>
        <c:ser>
          <c:idx val="2"/>
          <c:order val="2"/>
          <c:tx>
            <c:v>WL2</c:v>
          </c:tx>
          <c:spPr>
            <a:ln w="19050">
              <a:solidFill>
                <a:schemeClr val="tx1"/>
              </a:solidFill>
              <a:prstDash val="dashDot"/>
            </a:ln>
          </c:spPr>
          <c:marker>
            <c:symbol val="square"/>
            <c:size val="5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oids!$M$80:$M$93</c:f>
                <c:numCache>
                  <c:formatCode>General</c:formatCode>
                  <c:ptCount val="14"/>
                  <c:pt idx="0">
                    <c:v>0.343253738875049</c:v>
                  </c:pt>
                  <c:pt idx="1">
                    <c:v>0.56944596537599</c:v>
                  </c:pt>
                  <c:pt idx="2">
                    <c:v>0.695282940497564</c:v>
                  </c:pt>
                  <c:pt idx="3">
                    <c:v>0.803552909839523</c:v>
                  </c:pt>
                  <c:pt idx="4">
                    <c:v>0.728337964461685</c:v>
                  </c:pt>
                  <c:pt idx="5">
                    <c:v>0.724463207330441</c:v>
                  </c:pt>
                  <c:pt idx="6">
                    <c:v>0.766596417958766</c:v>
                  </c:pt>
                  <c:pt idx="7">
                    <c:v>0.812759639310735</c:v>
                  </c:pt>
                  <c:pt idx="8">
                    <c:v>0.878445596873629</c:v>
                  </c:pt>
                  <c:pt idx="9">
                    <c:v>0.906383259027271</c:v>
                  </c:pt>
                  <c:pt idx="10">
                    <c:v>0.995944156017174</c:v>
                  </c:pt>
                  <c:pt idx="11">
                    <c:v>0.944082897317181</c:v>
                  </c:pt>
                  <c:pt idx="12">
                    <c:v>0.954956833998112</c:v>
                  </c:pt>
                  <c:pt idx="13">
                    <c:v>1.051941192324382</c:v>
                  </c:pt>
                </c:numCache>
              </c:numRef>
            </c:plus>
            <c:minus>
              <c:numRef>
                <c:f>Poids!$M$80:$M$93</c:f>
                <c:numCache>
                  <c:formatCode>General</c:formatCode>
                  <c:ptCount val="14"/>
                  <c:pt idx="0">
                    <c:v>0.343253738875049</c:v>
                  </c:pt>
                  <c:pt idx="1">
                    <c:v>0.56944596537599</c:v>
                  </c:pt>
                  <c:pt idx="2">
                    <c:v>0.695282940497564</c:v>
                  </c:pt>
                  <c:pt idx="3">
                    <c:v>0.803552909839523</c:v>
                  </c:pt>
                  <c:pt idx="4">
                    <c:v>0.728337964461685</c:v>
                  </c:pt>
                  <c:pt idx="5">
                    <c:v>0.724463207330441</c:v>
                  </c:pt>
                  <c:pt idx="6">
                    <c:v>0.766596417958766</c:v>
                  </c:pt>
                  <c:pt idx="7">
                    <c:v>0.812759639310735</c:v>
                  </c:pt>
                  <c:pt idx="8">
                    <c:v>0.878445596873629</c:v>
                  </c:pt>
                  <c:pt idx="9">
                    <c:v>0.906383259027271</c:v>
                  </c:pt>
                  <c:pt idx="10">
                    <c:v>0.995944156017174</c:v>
                  </c:pt>
                  <c:pt idx="11">
                    <c:v>0.944082897317181</c:v>
                  </c:pt>
                  <c:pt idx="12">
                    <c:v>0.954956833998112</c:v>
                  </c:pt>
                  <c:pt idx="13">
                    <c:v>1.051941192324382</c:v>
                  </c:pt>
                </c:numCache>
              </c:numRef>
            </c:minus>
            <c:spPr>
              <a:ln w="3175">
                <a:solidFill>
                  <a:schemeClr val="tx1"/>
                </a:solidFill>
                <a:prstDash val="solid"/>
              </a:ln>
            </c:spPr>
          </c:errBars>
          <c:cat>
            <c:numRef>
              <c:f>Poids!$C$83:$C$95</c:f>
              <c:numCache>
                <c:formatCode>General</c:formatCode>
                <c:ptCount val="13"/>
                <c:pt idx="0">
                  <c:v>10.0</c:v>
                </c:pt>
                <c:pt idx="1">
                  <c:v>11.0</c:v>
                </c:pt>
                <c:pt idx="2">
                  <c:v>12.0</c:v>
                </c:pt>
                <c:pt idx="3">
                  <c:v>13.0</c:v>
                </c:pt>
                <c:pt idx="4">
                  <c:v>14.0</c:v>
                </c:pt>
                <c:pt idx="5">
                  <c:v>15.0</c:v>
                </c:pt>
                <c:pt idx="6">
                  <c:v>16.0</c:v>
                </c:pt>
                <c:pt idx="7">
                  <c:v>17.0</c:v>
                </c:pt>
                <c:pt idx="8">
                  <c:v>18.0</c:v>
                </c:pt>
                <c:pt idx="9">
                  <c:v>19.0</c:v>
                </c:pt>
                <c:pt idx="10">
                  <c:v>20.0</c:v>
                </c:pt>
                <c:pt idx="11">
                  <c:v>21.0</c:v>
                </c:pt>
                <c:pt idx="12">
                  <c:v>22.0</c:v>
                </c:pt>
              </c:numCache>
            </c:numRef>
          </c:cat>
          <c:val>
            <c:numRef>
              <c:f>Poids!$K$83:$K$93</c:f>
              <c:numCache>
                <c:formatCode>General</c:formatCode>
                <c:ptCount val="11"/>
                <c:pt idx="0">
                  <c:v>24.92142857142857</c:v>
                </c:pt>
                <c:pt idx="1">
                  <c:v>25.3</c:v>
                </c:pt>
                <c:pt idx="2">
                  <c:v>25.53571428571428</c:v>
                </c:pt>
                <c:pt idx="3">
                  <c:v>25.70714285714286</c:v>
                </c:pt>
                <c:pt idx="4">
                  <c:v>25.72142857142856</c:v>
                </c:pt>
                <c:pt idx="5">
                  <c:v>26.4</c:v>
                </c:pt>
                <c:pt idx="6">
                  <c:v>26.67142857142857</c:v>
                </c:pt>
                <c:pt idx="7">
                  <c:v>27.5</c:v>
                </c:pt>
                <c:pt idx="8">
                  <c:v>27.7</c:v>
                </c:pt>
                <c:pt idx="9">
                  <c:v>28.4095238095238</c:v>
                </c:pt>
                <c:pt idx="10">
                  <c:v>28.51571428571429</c:v>
                </c:pt>
              </c:numCache>
            </c:numRef>
          </c:val>
          <c:smooth val="0"/>
        </c:ser>
        <c:ser>
          <c:idx val="3"/>
          <c:order val="3"/>
          <c:tx>
            <c:v>WL4</c:v>
          </c:tx>
          <c:spPr>
            <a:ln w="19050">
              <a:solidFill>
                <a:schemeClr val="tx1"/>
              </a:solidFill>
              <a:prstDash val="lgDash"/>
            </a:ln>
          </c:spPr>
          <c:marker>
            <c:symbol val="triang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oids!$P$80:$P$95</c:f>
                <c:numCache>
                  <c:formatCode>General</c:formatCode>
                  <c:ptCount val="16"/>
                  <c:pt idx="0">
                    <c:v>0.500119033450086</c:v>
                  </c:pt>
                  <c:pt idx="1">
                    <c:v>0.53523788340955</c:v>
                  </c:pt>
                  <c:pt idx="2">
                    <c:v>0.572053230005027</c:v>
                  </c:pt>
                  <c:pt idx="3">
                    <c:v>0.557280202851129</c:v>
                  </c:pt>
                  <c:pt idx="4">
                    <c:v>0.560900029896073</c:v>
                  </c:pt>
                  <c:pt idx="5">
                    <c:v>0.654510774350962</c:v>
                  </c:pt>
                  <c:pt idx="6">
                    <c:v>0.417169764298538</c:v>
                  </c:pt>
                  <c:pt idx="7">
                    <c:v>0.382637641412669</c:v>
                  </c:pt>
                  <c:pt idx="8">
                    <c:v>0.512314343342598</c:v>
                  </c:pt>
                  <c:pt idx="9">
                    <c:v>0.484732902116782</c:v>
                  </c:pt>
                  <c:pt idx="10">
                    <c:v>0.516727009862159</c:v>
                  </c:pt>
                  <c:pt idx="11">
                    <c:v>0.748962245006011</c:v>
                  </c:pt>
                  <c:pt idx="12">
                    <c:v>0.963690782571988</c:v>
                  </c:pt>
                  <c:pt idx="13">
                    <c:v>0.891951922074568</c:v>
                  </c:pt>
                  <c:pt idx="14">
                    <c:v>0.923613135728264</c:v>
                  </c:pt>
                  <c:pt idx="15">
                    <c:v>0.984514452653181</c:v>
                  </c:pt>
                </c:numCache>
              </c:numRef>
            </c:plus>
            <c:minus>
              <c:numRef>
                <c:f>Poids!$P$80:$P$95</c:f>
                <c:numCache>
                  <c:formatCode>General</c:formatCode>
                  <c:ptCount val="16"/>
                  <c:pt idx="0">
                    <c:v>0.500119033450086</c:v>
                  </c:pt>
                  <c:pt idx="1">
                    <c:v>0.53523788340955</c:v>
                  </c:pt>
                  <c:pt idx="2">
                    <c:v>0.572053230005027</c:v>
                  </c:pt>
                  <c:pt idx="3">
                    <c:v>0.557280202851129</c:v>
                  </c:pt>
                  <c:pt idx="4">
                    <c:v>0.560900029896073</c:v>
                  </c:pt>
                  <c:pt idx="5">
                    <c:v>0.654510774350962</c:v>
                  </c:pt>
                  <c:pt idx="6">
                    <c:v>0.417169764298538</c:v>
                  </c:pt>
                  <c:pt idx="7">
                    <c:v>0.382637641412669</c:v>
                  </c:pt>
                  <c:pt idx="8">
                    <c:v>0.512314343342598</c:v>
                  </c:pt>
                  <c:pt idx="9">
                    <c:v>0.484732902116782</c:v>
                  </c:pt>
                  <c:pt idx="10">
                    <c:v>0.516727009862159</c:v>
                  </c:pt>
                  <c:pt idx="11">
                    <c:v>0.748962245006011</c:v>
                  </c:pt>
                  <c:pt idx="12">
                    <c:v>0.963690782571988</c:v>
                  </c:pt>
                  <c:pt idx="13">
                    <c:v>0.891951922074568</c:v>
                  </c:pt>
                  <c:pt idx="14">
                    <c:v>0.923613135728264</c:v>
                  </c:pt>
                  <c:pt idx="15">
                    <c:v>0.984514452653181</c:v>
                  </c:pt>
                </c:numCache>
              </c:numRef>
            </c:minus>
            <c:spPr>
              <a:ln w="3175">
                <a:solidFill>
                  <a:schemeClr val="tx1"/>
                </a:solidFill>
                <a:prstDash val="solid"/>
              </a:ln>
            </c:spPr>
          </c:errBars>
          <c:cat>
            <c:numRef>
              <c:f>Poids!$C$83:$C$95</c:f>
              <c:numCache>
                <c:formatCode>General</c:formatCode>
                <c:ptCount val="13"/>
                <c:pt idx="0">
                  <c:v>10.0</c:v>
                </c:pt>
                <c:pt idx="1">
                  <c:v>11.0</c:v>
                </c:pt>
                <c:pt idx="2">
                  <c:v>12.0</c:v>
                </c:pt>
                <c:pt idx="3">
                  <c:v>13.0</c:v>
                </c:pt>
                <c:pt idx="4">
                  <c:v>14.0</c:v>
                </c:pt>
                <c:pt idx="5">
                  <c:v>15.0</c:v>
                </c:pt>
                <c:pt idx="6">
                  <c:v>16.0</c:v>
                </c:pt>
                <c:pt idx="7">
                  <c:v>17.0</c:v>
                </c:pt>
                <c:pt idx="8">
                  <c:v>18.0</c:v>
                </c:pt>
                <c:pt idx="9">
                  <c:v>19.0</c:v>
                </c:pt>
                <c:pt idx="10">
                  <c:v>20.0</c:v>
                </c:pt>
                <c:pt idx="11">
                  <c:v>21.0</c:v>
                </c:pt>
                <c:pt idx="12">
                  <c:v>22.0</c:v>
                </c:pt>
              </c:numCache>
            </c:numRef>
          </c:cat>
          <c:val>
            <c:numRef>
              <c:f>Poids!$N$83:$N$95</c:f>
              <c:numCache>
                <c:formatCode>General</c:formatCode>
                <c:ptCount val="13"/>
                <c:pt idx="0">
                  <c:v>25.01428571428571</c:v>
                </c:pt>
                <c:pt idx="1">
                  <c:v>25.23571428571428</c:v>
                </c:pt>
                <c:pt idx="2">
                  <c:v>25.69285714285714</c:v>
                </c:pt>
                <c:pt idx="3">
                  <c:v>25.67857142857143</c:v>
                </c:pt>
                <c:pt idx="4">
                  <c:v>26.27857142857143</c:v>
                </c:pt>
                <c:pt idx="5">
                  <c:v>26.76428571428571</c:v>
                </c:pt>
                <c:pt idx="6">
                  <c:v>26.96428571428572</c:v>
                </c:pt>
                <c:pt idx="7">
                  <c:v>27.52857142857143</c:v>
                </c:pt>
                <c:pt idx="8">
                  <c:v>27.18333333333332</c:v>
                </c:pt>
                <c:pt idx="9">
                  <c:v>28.77142857142857</c:v>
                </c:pt>
                <c:pt idx="10">
                  <c:v>29.37142857142857</c:v>
                </c:pt>
                <c:pt idx="11">
                  <c:v>30.48571428571428</c:v>
                </c:pt>
                <c:pt idx="12">
                  <c:v>30.2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65167848"/>
        <c:axId val="2065173608"/>
      </c:lineChart>
      <c:catAx>
        <c:axId val="206516784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fr-FR"/>
                  <a:t>Age (week)</a:t>
                </a:r>
              </a:p>
            </c:rich>
          </c:tx>
          <c:layout>
            <c:manualLayout>
              <c:xMode val="edge"/>
              <c:yMode val="edge"/>
              <c:x val="0.431937907263615"/>
              <c:y val="0.90369629307411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3175">
            <a:solidFill>
              <a:schemeClr val="tx1"/>
            </a:solidFill>
            <a:prstDash val="solid"/>
          </a:ln>
        </c:spPr>
        <c:crossAx val="2065173608"/>
        <c:crosses val="autoZero"/>
        <c:auto val="1"/>
        <c:lblAlgn val="ctr"/>
        <c:lblOffset val="100"/>
        <c:noMultiLvlLbl val="0"/>
      </c:catAx>
      <c:valAx>
        <c:axId val="2065173608"/>
        <c:scaling>
          <c:orientation val="minMax"/>
          <c:min val="20.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fr-FR"/>
                  <a:t>Body weight (g)</a:t>
                </a:r>
              </a:p>
            </c:rich>
          </c:tx>
          <c:layout>
            <c:manualLayout>
              <c:xMode val="edge"/>
              <c:yMode val="edge"/>
              <c:x val="0.0174503907112363"/>
              <c:y val="0.3719963404816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3175">
            <a:solidFill>
              <a:schemeClr val="tx1"/>
            </a:solidFill>
            <a:prstDash val="solid"/>
          </a:ln>
        </c:spPr>
        <c:crossAx val="2065167848"/>
        <c:crosses val="autoZero"/>
        <c:crossBetween val="between"/>
      </c:valAx>
      <c:spPr>
        <a:noFill/>
        <a:ln w="25400">
          <a:noFill/>
        </a:ln>
      </c:spPr>
    </c:plotArea>
    <c:legend>
      <c:legendPos val="r"/>
      <c:layout>
        <c:manualLayout>
          <c:xMode val="edge"/>
          <c:yMode val="edge"/>
          <c:x val="0.800796215444687"/>
          <c:y val="0.621093739685159"/>
          <c:w val="0.105465252265365"/>
          <c:h val="0.157280070218812"/>
        </c:manualLayout>
      </c:layout>
      <c:overlay val="0"/>
      <c:spPr>
        <a:noFill/>
        <a:ln w="25400">
          <a:noFill/>
        </a:ln>
      </c:spPr>
    </c:legend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txPr>
    <a:bodyPr/>
    <a:lstStyle/>
    <a:p>
      <a:pPr>
        <a:defRPr sz="1400"/>
      </a:pPr>
      <a:endParaRPr lang="fr-F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6153479092367"/>
          <c:y val="0.0436400949148859"/>
          <c:w val="0.782415585959867"/>
          <c:h val="0.776315714909074"/>
        </c:manualLayout>
      </c:layout>
      <c:lineChart>
        <c:grouping val="standard"/>
        <c:varyColors val="0"/>
        <c:ser>
          <c:idx val="0"/>
          <c:order val="0"/>
          <c:tx>
            <c:strRef>
              <c:f>course!$AQ$33</c:f>
              <c:strCache>
                <c:ptCount val="1"/>
                <c:pt idx="0">
                  <c:v>EX</c:v>
                </c:pt>
              </c:strCache>
            </c:strRef>
          </c:tx>
          <c:spPr>
            <a:ln w="19050">
              <a:solidFill>
                <a:schemeClr val="tx1"/>
              </a:solidFill>
              <a:prstDash val="dash"/>
            </a:ln>
          </c:spPr>
          <c:marker>
            <c:symbol val="square"/>
            <c:size val="5"/>
            <c:spPr>
              <a:solidFill>
                <a:schemeClr val="tx1"/>
              </a:solidFill>
              <a:ln w="19050">
                <a:solidFill>
                  <a:schemeClr val="tx1"/>
                </a:solidFill>
                <a:prstDash val="dash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ourse!$AS$34:$AS$46</c:f>
                <c:numCache>
                  <c:formatCode>General</c:formatCode>
                  <c:ptCount val="13"/>
                  <c:pt idx="0">
                    <c:v>0.858061626528441</c:v>
                  </c:pt>
                  <c:pt idx="1">
                    <c:v>0.416654408278376</c:v>
                  </c:pt>
                  <c:pt idx="2">
                    <c:v>0.249404006267347</c:v>
                  </c:pt>
                  <c:pt idx="3">
                    <c:v>0.333369785335072</c:v>
                  </c:pt>
                  <c:pt idx="4">
                    <c:v>0.240730731229787</c:v>
                  </c:pt>
                  <c:pt idx="5">
                    <c:v>0.432121973275051</c:v>
                  </c:pt>
                  <c:pt idx="6">
                    <c:v>0.381380118527066</c:v>
                  </c:pt>
                  <c:pt idx="7">
                    <c:v>0.37128655473415</c:v>
                  </c:pt>
                  <c:pt idx="8">
                    <c:v>0.37950619723708</c:v>
                  </c:pt>
                  <c:pt idx="9">
                    <c:v>0.503696680933528</c:v>
                  </c:pt>
                  <c:pt idx="10">
                    <c:v>0.479568406577761</c:v>
                  </c:pt>
                  <c:pt idx="11">
                    <c:v>0.47854405009947</c:v>
                  </c:pt>
                  <c:pt idx="12">
                    <c:v>0.311108295612059</c:v>
                  </c:pt>
                </c:numCache>
              </c:numRef>
            </c:plus>
            <c:minus>
              <c:numRef>
                <c:f>course!$AS$34:$AS$46</c:f>
                <c:numCache>
                  <c:formatCode>General</c:formatCode>
                  <c:ptCount val="13"/>
                  <c:pt idx="0">
                    <c:v>0.858061626528441</c:v>
                  </c:pt>
                  <c:pt idx="1">
                    <c:v>0.416654408278376</c:v>
                  </c:pt>
                  <c:pt idx="2">
                    <c:v>0.249404006267347</c:v>
                  </c:pt>
                  <c:pt idx="3">
                    <c:v>0.333369785335072</c:v>
                  </c:pt>
                  <c:pt idx="4">
                    <c:v>0.240730731229787</c:v>
                  </c:pt>
                  <c:pt idx="5">
                    <c:v>0.432121973275051</c:v>
                  </c:pt>
                  <c:pt idx="6">
                    <c:v>0.381380118527066</c:v>
                  </c:pt>
                  <c:pt idx="7">
                    <c:v>0.37128655473415</c:v>
                  </c:pt>
                  <c:pt idx="8">
                    <c:v>0.37950619723708</c:v>
                  </c:pt>
                  <c:pt idx="9">
                    <c:v>0.503696680933528</c:v>
                  </c:pt>
                  <c:pt idx="10">
                    <c:v>0.479568406577761</c:v>
                  </c:pt>
                  <c:pt idx="11">
                    <c:v>0.47854405009947</c:v>
                  </c:pt>
                  <c:pt idx="12">
                    <c:v>0.311108295612059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numRef>
              <c:f>course!$AO$34:$AO$46</c:f>
              <c:numCache>
                <c:formatCode>0</c:formatCode>
                <c:ptCount val="13"/>
                <c:pt idx="0">
                  <c:v>10.0</c:v>
                </c:pt>
                <c:pt idx="1">
                  <c:v>11.0</c:v>
                </c:pt>
                <c:pt idx="2">
                  <c:v>12.0</c:v>
                </c:pt>
                <c:pt idx="3">
                  <c:v>13.0</c:v>
                </c:pt>
                <c:pt idx="4">
                  <c:v>14.0</c:v>
                </c:pt>
                <c:pt idx="5">
                  <c:v>15.0</c:v>
                </c:pt>
                <c:pt idx="6">
                  <c:v>16.0</c:v>
                </c:pt>
                <c:pt idx="7">
                  <c:v>17.0</c:v>
                </c:pt>
                <c:pt idx="8">
                  <c:v>18.0</c:v>
                </c:pt>
                <c:pt idx="9">
                  <c:v>19.0</c:v>
                </c:pt>
                <c:pt idx="10">
                  <c:v>20.0</c:v>
                </c:pt>
                <c:pt idx="11">
                  <c:v>21.0</c:v>
                </c:pt>
                <c:pt idx="12">
                  <c:v>22.0</c:v>
                </c:pt>
              </c:numCache>
            </c:numRef>
          </c:cat>
          <c:val>
            <c:numRef>
              <c:f>course!$AQ$34:$AQ$46</c:f>
              <c:numCache>
                <c:formatCode>0.00</c:formatCode>
                <c:ptCount val="13"/>
                <c:pt idx="0">
                  <c:v>7.045200000000001</c:v>
                </c:pt>
                <c:pt idx="1">
                  <c:v>7.54264761904762</c:v>
                </c:pt>
                <c:pt idx="2">
                  <c:v>8.10313945578231</c:v>
                </c:pt>
                <c:pt idx="3">
                  <c:v>7.385629251700682</c:v>
                </c:pt>
                <c:pt idx="4">
                  <c:v>7.262857142857142</c:v>
                </c:pt>
                <c:pt idx="5">
                  <c:v>5.94108843537415</c:v>
                </c:pt>
                <c:pt idx="6">
                  <c:v>4.983775510204083</c:v>
                </c:pt>
                <c:pt idx="7">
                  <c:v>5.09045189504373</c:v>
                </c:pt>
                <c:pt idx="8">
                  <c:v>3.666575963718819</c:v>
                </c:pt>
                <c:pt idx="9">
                  <c:v>4.204591836734694</c:v>
                </c:pt>
                <c:pt idx="10">
                  <c:v>4.511734693877552</c:v>
                </c:pt>
                <c:pt idx="11">
                  <c:v>4.644897959183672</c:v>
                </c:pt>
                <c:pt idx="12">
                  <c:v>3.213392857142854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course!$AT$33</c:f>
              <c:strCache>
                <c:ptCount val="1"/>
                <c:pt idx="0">
                  <c:v>WL2</c:v>
                </c:pt>
              </c:strCache>
            </c:strRef>
          </c:tx>
          <c:spPr>
            <a:ln w="19050">
              <a:solidFill>
                <a:schemeClr val="tx1"/>
              </a:solidFill>
              <a:prstDash val="dashDot"/>
            </a:ln>
          </c:spPr>
          <c:marker>
            <c:symbol val="square"/>
            <c:size val="5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ourse!$AV$34:$AV$42</c:f>
                <c:numCache>
                  <c:formatCode>General</c:formatCode>
                  <c:ptCount val="9"/>
                  <c:pt idx="0">
                    <c:v>0.545417174445298</c:v>
                  </c:pt>
                  <c:pt idx="1">
                    <c:v>0.673789829056831</c:v>
                  </c:pt>
                  <c:pt idx="2">
                    <c:v>0.67905385530098</c:v>
                  </c:pt>
                  <c:pt idx="3">
                    <c:v>0.602145165876985</c:v>
                  </c:pt>
                  <c:pt idx="4">
                    <c:v>0.594914562868168</c:v>
                  </c:pt>
                  <c:pt idx="5">
                    <c:v>0.458011903748357</c:v>
                  </c:pt>
                  <c:pt idx="6">
                    <c:v>0.396252664112768</c:v>
                  </c:pt>
                  <c:pt idx="7">
                    <c:v>0.33222506064524</c:v>
                  </c:pt>
                  <c:pt idx="8">
                    <c:v>0.221485775864223</c:v>
                  </c:pt>
                </c:numCache>
              </c:numRef>
            </c:plus>
            <c:minus>
              <c:numRef>
                <c:f>course!$AV$34:$AV$42</c:f>
                <c:numCache>
                  <c:formatCode>General</c:formatCode>
                  <c:ptCount val="9"/>
                  <c:pt idx="0">
                    <c:v>0.545417174445298</c:v>
                  </c:pt>
                  <c:pt idx="1">
                    <c:v>0.673789829056831</c:v>
                  </c:pt>
                  <c:pt idx="2">
                    <c:v>0.67905385530098</c:v>
                  </c:pt>
                  <c:pt idx="3">
                    <c:v>0.602145165876985</c:v>
                  </c:pt>
                  <c:pt idx="4">
                    <c:v>0.594914562868168</c:v>
                  </c:pt>
                  <c:pt idx="5">
                    <c:v>0.458011903748357</c:v>
                  </c:pt>
                  <c:pt idx="6">
                    <c:v>0.396252664112768</c:v>
                  </c:pt>
                  <c:pt idx="7">
                    <c:v>0.33222506064524</c:v>
                  </c:pt>
                  <c:pt idx="8">
                    <c:v>0.221485775864223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numRef>
              <c:f>course!$AO$34:$AO$46</c:f>
              <c:numCache>
                <c:formatCode>0</c:formatCode>
                <c:ptCount val="13"/>
                <c:pt idx="0">
                  <c:v>10.0</c:v>
                </c:pt>
                <c:pt idx="1">
                  <c:v>11.0</c:v>
                </c:pt>
                <c:pt idx="2">
                  <c:v>12.0</c:v>
                </c:pt>
                <c:pt idx="3">
                  <c:v>13.0</c:v>
                </c:pt>
                <c:pt idx="4">
                  <c:v>14.0</c:v>
                </c:pt>
                <c:pt idx="5">
                  <c:v>15.0</c:v>
                </c:pt>
                <c:pt idx="6">
                  <c:v>16.0</c:v>
                </c:pt>
                <c:pt idx="7">
                  <c:v>17.0</c:v>
                </c:pt>
                <c:pt idx="8">
                  <c:v>18.0</c:v>
                </c:pt>
                <c:pt idx="9">
                  <c:v>19.0</c:v>
                </c:pt>
                <c:pt idx="10">
                  <c:v>20.0</c:v>
                </c:pt>
                <c:pt idx="11">
                  <c:v>21.0</c:v>
                </c:pt>
                <c:pt idx="12">
                  <c:v>22.0</c:v>
                </c:pt>
              </c:numCache>
            </c:numRef>
          </c:cat>
          <c:val>
            <c:numRef>
              <c:f>course!$AT$34:$AT$42</c:f>
              <c:numCache>
                <c:formatCode>0.00</c:formatCode>
                <c:ptCount val="9"/>
                <c:pt idx="0">
                  <c:v>6.355555555555555</c:v>
                </c:pt>
                <c:pt idx="1">
                  <c:v>6.551709656084656</c:v>
                </c:pt>
                <c:pt idx="2">
                  <c:v>7.185034013605443</c:v>
                </c:pt>
                <c:pt idx="3">
                  <c:v>6.450901360544218</c:v>
                </c:pt>
                <c:pt idx="4">
                  <c:v>6.253015873015873</c:v>
                </c:pt>
                <c:pt idx="5">
                  <c:v>5.403537414965986</c:v>
                </c:pt>
                <c:pt idx="6">
                  <c:v>3.786224489795917</c:v>
                </c:pt>
                <c:pt idx="7">
                  <c:v>3.716107871720117</c:v>
                </c:pt>
                <c:pt idx="8">
                  <c:v>3.891836734693877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course!$AW$33</c:f>
              <c:strCache>
                <c:ptCount val="1"/>
                <c:pt idx="0">
                  <c:v>WL4</c:v>
                </c:pt>
              </c:strCache>
            </c:strRef>
          </c:tx>
          <c:spPr>
            <a:ln w="19050">
              <a:solidFill>
                <a:schemeClr val="tx1"/>
              </a:solidFill>
              <a:prstDash val="lgDash"/>
            </a:ln>
          </c:spPr>
          <c:marker>
            <c:symbol val="triang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course!$AY$34:$AY$42</c:f>
                <c:numCache>
                  <c:formatCode>General</c:formatCode>
                  <c:ptCount val="9"/>
                  <c:pt idx="0">
                    <c:v>1.237263853798109</c:v>
                  </c:pt>
                  <c:pt idx="1">
                    <c:v>1.458623330106743</c:v>
                  </c:pt>
                  <c:pt idx="2">
                    <c:v>1.289711132161684</c:v>
                  </c:pt>
                  <c:pt idx="3">
                    <c:v>0.885779396059745</c:v>
                  </c:pt>
                  <c:pt idx="4">
                    <c:v>1.045636450959193</c:v>
                  </c:pt>
                  <c:pt idx="5">
                    <c:v>0.770751184316521</c:v>
                  </c:pt>
                  <c:pt idx="6">
                    <c:v>0.866361612525472</c:v>
                  </c:pt>
                  <c:pt idx="7">
                    <c:v>0.84206403074004</c:v>
                  </c:pt>
                  <c:pt idx="8">
                    <c:v>0.846502139767071</c:v>
                  </c:pt>
                </c:numCache>
              </c:numRef>
            </c:plus>
            <c:minus>
              <c:numRef>
                <c:f>course!$AY$34:$AY$42</c:f>
                <c:numCache>
                  <c:formatCode>General</c:formatCode>
                  <c:ptCount val="9"/>
                  <c:pt idx="0">
                    <c:v>1.237263853798109</c:v>
                  </c:pt>
                  <c:pt idx="1">
                    <c:v>1.458623330106743</c:v>
                  </c:pt>
                  <c:pt idx="2">
                    <c:v>1.289711132161684</c:v>
                  </c:pt>
                  <c:pt idx="3">
                    <c:v>0.885779396059745</c:v>
                  </c:pt>
                  <c:pt idx="4">
                    <c:v>1.045636450959193</c:v>
                  </c:pt>
                  <c:pt idx="5">
                    <c:v>0.770751184316521</c:v>
                  </c:pt>
                  <c:pt idx="6">
                    <c:v>0.866361612525472</c:v>
                  </c:pt>
                  <c:pt idx="7">
                    <c:v>0.84206403074004</c:v>
                  </c:pt>
                  <c:pt idx="8">
                    <c:v>0.846502139767071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numRef>
              <c:f>course!$AO$34:$AO$46</c:f>
              <c:numCache>
                <c:formatCode>0</c:formatCode>
                <c:ptCount val="13"/>
                <c:pt idx="0">
                  <c:v>10.0</c:v>
                </c:pt>
                <c:pt idx="1">
                  <c:v>11.0</c:v>
                </c:pt>
                <c:pt idx="2">
                  <c:v>12.0</c:v>
                </c:pt>
                <c:pt idx="3">
                  <c:v>13.0</c:v>
                </c:pt>
                <c:pt idx="4">
                  <c:v>14.0</c:v>
                </c:pt>
                <c:pt idx="5">
                  <c:v>15.0</c:v>
                </c:pt>
                <c:pt idx="6">
                  <c:v>16.0</c:v>
                </c:pt>
                <c:pt idx="7">
                  <c:v>17.0</c:v>
                </c:pt>
                <c:pt idx="8">
                  <c:v>18.0</c:v>
                </c:pt>
                <c:pt idx="9">
                  <c:v>19.0</c:v>
                </c:pt>
                <c:pt idx="10">
                  <c:v>20.0</c:v>
                </c:pt>
                <c:pt idx="11">
                  <c:v>21.0</c:v>
                </c:pt>
                <c:pt idx="12">
                  <c:v>22.0</c:v>
                </c:pt>
              </c:numCache>
            </c:numRef>
          </c:cat>
          <c:val>
            <c:numRef>
              <c:f>course!$AW$34:$AW$42</c:f>
              <c:numCache>
                <c:formatCode>0.00</c:formatCode>
                <c:ptCount val="9"/>
                <c:pt idx="0">
                  <c:v>9.150944444444442</c:v>
                </c:pt>
                <c:pt idx="1">
                  <c:v>8.01750680272109</c:v>
                </c:pt>
                <c:pt idx="2">
                  <c:v>7.913988095238095</c:v>
                </c:pt>
                <c:pt idx="3">
                  <c:v>7.375357142857142</c:v>
                </c:pt>
                <c:pt idx="4">
                  <c:v>5.965357142857143</c:v>
                </c:pt>
                <c:pt idx="5">
                  <c:v>5.504149659863947</c:v>
                </c:pt>
                <c:pt idx="6">
                  <c:v>5.022414965986391</c:v>
                </c:pt>
                <c:pt idx="7">
                  <c:v>4.88843051506317</c:v>
                </c:pt>
                <c:pt idx="8">
                  <c:v>4.35370748299319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146803928"/>
        <c:axId val="-2146798488"/>
      </c:lineChart>
      <c:catAx>
        <c:axId val="-214680392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400"/>
                </a:pPr>
                <a:r>
                  <a:rPr lang="fr-FR" sz="1400"/>
                  <a:t>Age (week)</a:t>
                </a:r>
              </a:p>
            </c:rich>
          </c:tx>
          <c:layout/>
          <c:overlay val="0"/>
        </c:title>
        <c:numFmt formatCode="0" sourceLinked="1"/>
        <c:majorTickMark val="out"/>
        <c:minorTickMark val="none"/>
        <c:tickLblPos val="nextTo"/>
        <c:spPr>
          <a:ln w="3175">
            <a:solidFill>
              <a:schemeClr val="tx1"/>
            </a:solidFill>
            <a:prstDash val="solid"/>
          </a:ln>
        </c:spPr>
        <c:txPr>
          <a:bodyPr/>
          <a:lstStyle/>
          <a:p>
            <a:pPr>
              <a:defRPr sz="1400"/>
            </a:pPr>
            <a:endParaRPr lang="fr-FR"/>
          </a:p>
        </c:txPr>
        <c:crossAx val="-2146798488"/>
        <c:crosses val="autoZero"/>
        <c:auto val="1"/>
        <c:lblAlgn val="ctr"/>
        <c:lblOffset val="100"/>
        <c:noMultiLvlLbl val="0"/>
      </c:catAx>
      <c:valAx>
        <c:axId val="-214679848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400"/>
                </a:pPr>
                <a:r>
                  <a:rPr lang="fr-FR" sz="1400"/>
                  <a:t>Running distance (Km/day)</a:t>
                </a:r>
              </a:p>
            </c:rich>
          </c:tx>
          <c:layout/>
          <c:overlay val="0"/>
        </c:title>
        <c:numFmt formatCode="0" sourceLinked="0"/>
        <c:majorTickMark val="out"/>
        <c:minorTickMark val="none"/>
        <c:tickLblPos val="nextTo"/>
        <c:spPr>
          <a:ln w="3175">
            <a:solidFill>
              <a:schemeClr val="tx1"/>
            </a:solidFill>
            <a:prstDash val="solid"/>
          </a:ln>
        </c:spPr>
        <c:txPr>
          <a:bodyPr/>
          <a:lstStyle/>
          <a:p>
            <a:pPr>
              <a:defRPr sz="1400"/>
            </a:pPr>
            <a:endParaRPr lang="fr-FR"/>
          </a:p>
        </c:txPr>
        <c:crossAx val="-2146803928"/>
        <c:crosses val="autoZero"/>
        <c:crossBetween val="between"/>
      </c:valAx>
      <c:spPr>
        <a:solidFill>
          <a:srgbClr val="FFFFFF"/>
        </a:solidFill>
        <a:ln w="25400">
          <a:noFill/>
        </a:ln>
      </c:spPr>
    </c:plotArea>
    <c:legend>
      <c:legendPos val="r"/>
      <c:layout>
        <c:manualLayout>
          <c:xMode val="edge"/>
          <c:yMode val="edge"/>
          <c:x val="0.752253346070116"/>
          <c:y val="0.153462667860235"/>
          <c:w val="0.121296028889674"/>
          <c:h val="0.135021173726562"/>
        </c:manualLayout>
      </c:layout>
      <c:overlay val="0"/>
      <c:spPr>
        <a:noFill/>
        <a:ln w="25400">
          <a:noFill/>
        </a:ln>
      </c:spPr>
      <c:txPr>
        <a:bodyPr/>
        <a:lstStyle/>
        <a:p>
          <a:pPr>
            <a:defRPr sz="1400"/>
          </a:pPr>
          <a:endParaRPr lang="fr-FR"/>
        </a:p>
      </c:txPr>
    </c:legend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5475471142892"/>
          <c:y val="0.0577080708081607"/>
          <c:w val="0.77675136414407"/>
          <c:h val="0.787972971456389"/>
        </c:manualLayout>
      </c:layout>
      <c:lineChart>
        <c:grouping val="standard"/>
        <c:varyColors val="0"/>
        <c:ser>
          <c:idx val="0"/>
          <c:order val="0"/>
          <c:tx>
            <c:v>SED</c:v>
          </c:tx>
          <c:spPr>
            <a:ln w="19050">
              <a:solidFill>
                <a:schemeClr val="tx1"/>
              </a:solidFill>
              <a:prstDash val="solid"/>
            </a:ln>
          </c:spPr>
          <c:marker>
            <c:symbol val="circ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riseAlimentaire!$F$257:$F$269</c:f>
                <c:numCache>
                  <c:formatCode>General</c:formatCode>
                  <c:ptCount val="13"/>
                  <c:pt idx="0">
                    <c:v>0.144608314511477</c:v>
                  </c:pt>
                  <c:pt idx="1">
                    <c:v>0.156946604194218</c:v>
                  </c:pt>
                  <c:pt idx="2">
                    <c:v>0.123596989965566</c:v>
                  </c:pt>
                  <c:pt idx="3">
                    <c:v>0.193375442575791</c:v>
                  </c:pt>
                  <c:pt idx="4">
                    <c:v>0.139364375427589</c:v>
                  </c:pt>
                  <c:pt idx="5">
                    <c:v>0.135239646201703</c:v>
                  </c:pt>
                  <c:pt idx="6">
                    <c:v>0.0894212304913382</c:v>
                  </c:pt>
                  <c:pt idx="7">
                    <c:v>0.121449916424617</c:v>
                  </c:pt>
                  <c:pt idx="8">
                    <c:v>0.075471626003158</c:v>
                  </c:pt>
                  <c:pt idx="9">
                    <c:v>0.0781645176653526</c:v>
                  </c:pt>
                  <c:pt idx="10">
                    <c:v>0.0840107135474077</c:v>
                  </c:pt>
                  <c:pt idx="11">
                    <c:v>0.117534430715549</c:v>
                  </c:pt>
                  <c:pt idx="12">
                    <c:v>0.119385919124431</c:v>
                  </c:pt>
                </c:numCache>
              </c:numRef>
            </c:plus>
            <c:minus>
              <c:numRef>
                <c:f>PriseAlimentaire!$F$257:$F$269</c:f>
                <c:numCache>
                  <c:formatCode>General</c:formatCode>
                  <c:ptCount val="13"/>
                  <c:pt idx="0">
                    <c:v>0.144608314511477</c:v>
                  </c:pt>
                  <c:pt idx="1">
                    <c:v>0.156946604194218</c:v>
                  </c:pt>
                  <c:pt idx="2">
                    <c:v>0.123596989965566</c:v>
                  </c:pt>
                  <c:pt idx="3">
                    <c:v>0.193375442575791</c:v>
                  </c:pt>
                  <c:pt idx="4">
                    <c:v>0.139364375427589</c:v>
                  </c:pt>
                  <c:pt idx="5">
                    <c:v>0.135239646201703</c:v>
                  </c:pt>
                  <c:pt idx="6">
                    <c:v>0.0894212304913382</c:v>
                  </c:pt>
                  <c:pt idx="7">
                    <c:v>0.121449916424617</c:v>
                  </c:pt>
                  <c:pt idx="8">
                    <c:v>0.075471626003158</c:v>
                  </c:pt>
                  <c:pt idx="9">
                    <c:v>0.0781645176653526</c:v>
                  </c:pt>
                  <c:pt idx="10">
                    <c:v>0.0840107135474077</c:v>
                  </c:pt>
                  <c:pt idx="11">
                    <c:v>0.117534430715549</c:v>
                  </c:pt>
                  <c:pt idx="12">
                    <c:v>0.119385919124431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numRef>
              <c:f>PriseAlimentaire!$C$257:$C$269</c:f>
              <c:numCache>
                <c:formatCode>General</c:formatCode>
                <c:ptCount val="13"/>
                <c:pt idx="0">
                  <c:v>10.0</c:v>
                </c:pt>
                <c:pt idx="1">
                  <c:v>11.0</c:v>
                </c:pt>
                <c:pt idx="2">
                  <c:v>12.0</c:v>
                </c:pt>
                <c:pt idx="3">
                  <c:v>13.0</c:v>
                </c:pt>
                <c:pt idx="4">
                  <c:v>14.0</c:v>
                </c:pt>
                <c:pt idx="5">
                  <c:v>15.0</c:v>
                </c:pt>
                <c:pt idx="6">
                  <c:v>16.0</c:v>
                </c:pt>
                <c:pt idx="7">
                  <c:v>17.0</c:v>
                </c:pt>
                <c:pt idx="8">
                  <c:v>18.0</c:v>
                </c:pt>
                <c:pt idx="9">
                  <c:v>19.0</c:v>
                </c:pt>
                <c:pt idx="10">
                  <c:v>20.0</c:v>
                </c:pt>
                <c:pt idx="11">
                  <c:v>21.0</c:v>
                </c:pt>
                <c:pt idx="12">
                  <c:v>22.0</c:v>
                </c:pt>
              </c:numCache>
            </c:numRef>
          </c:cat>
          <c:val>
            <c:numRef>
              <c:f>PriseAlimentaire!$D$257:$D$269</c:f>
              <c:numCache>
                <c:formatCode>0.00</c:formatCode>
                <c:ptCount val="13"/>
                <c:pt idx="0">
                  <c:v>3.585714285714285</c:v>
                </c:pt>
                <c:pt idx="1">
                  <c:v>3.585714285714286</c:v>
                </c:pt>
                <c:pt idx="2">
                  <c:v>3.55034013605442</c:v>
                </c:pt>
                <c:pt idx="3">
                  <c:v>3.361309523809524</c:v>
                </c:pt>
                <c:pt idx="4">
                  <c:v>3.640119047619047</c:v>
                </c:pt>
                <c:pt idx="5">
                  <c:v>3.623571428571428</c:v>
                </c:pt>
                <c:pt idx="6">
                  <c:v>3.377857142857143</c:v>
                </c:pt>
                <c:pt idx="7">
                  <c:v>3.101309523809524</c:v>
                </c:pt>
                <c:pt idx="8">
                  <c:v>3.301357323232323</c:v>
                </c:pt>
                <c:pt idx="9">
                  <c:v>3.145887445887446</c:v>
                </c:pt>
                <c:pt idx="10">
                  <c:v>3.166666666666666</c:v>
                </c:pt>
                <c:pt idx="11">
                  <c:v>2.998809523809522</c:v>
                </c:pt>
                <c:pt idx="12">
                  <c:v>3.183333333333333</c:v>
                </c:pt>
              </c:numCache>
            </c:numRef>
          </c:val>
          <c:smooth val="0"/>
        </c:ser>
        <c:ser>
          <c:idx val="1"/>
          <c:order val="1"/>
          <c:tx>
            <c:v>EX</c:v>
          </c:tx>
          <c:spPr>
            <a:ln w="19050">
              <a:solidFill>
                <a:schemeClr val="tx1"/>
              </a:solidFill>
              <a:prstDash val="dash"/>
            </a:ln>
          </c:spPr>
          <c:marker>
            <c:symbol val="squar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riseAlimentaire!$I$257:$I$269</c:f>
                <c:numCache>
                  <c:formatCode>General</c:formatCode>
                  <c:ptCount val="13"/>
                  <c:pt idx="0">
                    <c:v>0.190106541221315</c:v>
                  </c:pt>
                  <c:pt idx="1">
                    <c:v>0.160770364773327</c:v>
                  </c:pt>
                  <c:pt idx="2">
                    <c:v>0.106739595655512</c:v>
                  </c:pt>
                  <c:pt idx="3">
                    <c:v>0.09387431597502</c:v>
                  </c:pt>
                  <c:pt idx="4">
                    <c:v>0.103960313447865</c:v>
                  </c:pt>
                  <c:pt idx="5">
                    <c:v>0.0860768973902658</c:v>
                  </c:pt>
                  <c:pt idx="6">
                    <c:v>0.125945542222501</c:v>
                  </c:pt>
                  <c:pt idx="7">
                    <c:v>0.116966849688884</c:v>
                  </c:pt>
                  <c:pt idx="8">
                    <c:v>0.104043362301409</c:v>
                  </c:pt>
                  <c:pt idx="9">
                    <c:v>0.100946950450082</c:v>
                  </c:pt>
                  <c:pt idx="10">
                    <c:v>0.107947075300402</c:v>
                  </c:pt>
                  <c:pt idx="11">
                    <c:v>0.0987404186555525</c:v>
                  </c:pt>
                  <c:pt idx="12">
                    <c:v>0.110997403197682</c:v>
                  </c:pt>
                </c:numCache>
              </c:numRef>
            </c:plus>
            <c:minus>
              <c:numRef>
                <c:f>PriseAlimentaire!$I$257:$I$269</c:f>
                <c:numCache>
                  <c:formatCode>General</c:formatCode>
                  <c:ptCount val="13"/>
                  <c:pt idx="0">
                    <c:v>0.190106541221315</c:v>
                  </c:pt>
                  <c:pt idx="1">
                    <c:v>0.160770364773327</c:v>
                  </c:pt>
                  <c:pt idx="2">
                    <c:v>0.106739595655512</c:v>
                  </c:pt>
                  <c:pt idx="3">
                    <c:v>0.09387431597502</c:v>
                  </c:pt>
                  <c:pt idx="4">
                    <c:v>0.103960313447865</c:v>
                  </c:pt>
                  <c:pt idx="5">
                    <c:v>0.0860768973902658</c:v>
                  </c:pt>
                  <c:pt idx="6">
                    <c:v>0.125945542222501</c:v>
                  </c:pt>
                  <c:pt idx="7">
                    <c:v>0.116966849688884</c:v>
                  </c:pt>
                  <c:pt idx="8">
                    <c:v>0.104043362301409</c:v>
                  </c:pt>
                  <c:pt idx="9">
                    <c:v>0.100946950450082</c:v>
                  </c:pt>
                  <c:pt idx="10">
                    <c:v>0.107947075300402</c:v>
                  </c:pt>
                  <c:pt idx="11">
                    <c:v>0.0987404186555525</c:v>
                  </c:pt>
                  <c:pt idx="12">
                    <c:v>0.110997403197682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numRef>
              <c:f>PriseAlimentaire!$C$257:$C$269</c:f>
              <c:numCache>
                <c:formatCode>General</c:formatCode>
                <c:ptCount val="13"/>
                <c:pt idx="0">
                  <c:v>10.0</c:v>
                </c:pt>
                <c:pt idx="1">
                  <c:v>11.0</c:v>
                </c:pt>
                <c:pt idx="2">
                  <c:v>12.0</c:v>
                </c:pt>
                <c:pt idx="3">
                  <c:v>13.0</c:v>
                </c:pt>
                <c:pt idx="4">
                  <c:v>14.0</c:v>
                </c:pt>
                <c:pt idx="5">
                  <c:v>15.0</c:v>
                </c:pt>
                <c:pt idx="6">
                  <c:v>16.0</c:v>
                </c:pt>
                <c:pt idx="7">
                  <c:v>17.0</c:v>
                </c:pt>
                <c:pt idx="8">
                  <c:v>18.0</c:v>
                </c:pt>
                <c:pt idx="9">
                  <c:v>19.0</c:v>
                </c:pt>
                <c:pt idx="10">
                  <c:v>20.0</c:v>
                </c:pt>
                <c:pt idx="11">
                  <c:v>21.0</c:v>
                </c:pt>
                <c:pt idx="12">
                  <c:v>22.0</c:v>
                </c:pt>
              </c:numCache>
            </c:numRef>
          </c:cat>
          <c:val>
            <c:numRef>
              <c:f>PriseAlimentaire!$G$257:$G$269</c:f>
              <c:numCache>
                <c:formatCode>0.00</c:formatCode>
                <c:ptCount val="13"/>
                <c:pt idx="0">
                  <c:v>4.448979591836735</c:v>
                </c:pt>
                <c:pt idx="1">
                  <c:v>4.349562682215742</c:v>
                </c:pt>
                <c:pt idx="2">
                  <c:v>4.314067055393586</c:v>
                </c:pt>
                <c:pt idx="3">
                  <c:v>4.197448979591837</c:v>
                </c:pt>
                <c:pt idx="4">
                  <c:v>4.23530612244898</c:v>
                </c:pt>
                <c:pt idx="5">
                  <c:v>4.119285714285715</c:v>
                </c:pt>
                <c:pt idx="6">
                  <c:v>3.830102040816326</c:v>
                </c:pt>
                <c:pt idx="7">
                  <c:v>3.474999999999999</c:v>
                </c:pt>
                <c:pt idx="8">
                  <c:v>3.775514069264069</c:v>
                </c:pt>
                <c:pt idx="9">
                  <c:v>3.442777630532732</c:v>
                </c:pt>
                <c:pt idx="10">
                  <c:v>3.638483965014577</c:v>
                </c:pt>
                <c:pt idx="11">
                  <c:v>3.459183673469387</c:v>
                </c:pt>
                <c:pt idx="12">
                  <c:v>3.795357142857142</c:v>
                </c:pt>
              </c:numCache>
            </c:numRef>
          </c:val>
          <c:smooth val="0"/>
        </c:ser>
        <c:ser>
          <c:idx val="3"/>
          <c:order val="2"/>
          <c:tx>
            <c:v>WL2</c:v>
          </c:tx>
          <c:spPr>
            <a:ln w="19050">
              <a:solidFill>
                <a:schemeClr val="tx1"/>
              </a:solidFill>
              <a:prstDash val="dashDot"/>
            </a:ln>
          </c:spPr>
          <c:marker>
            <c:symbol val="square"/>
            <c:size val="5"/>
            <c:spPr>
              <a:solidFill>
                <a:schemeClr val="bg1"/>
              </a:solidFill>
              <a:ln>
                <a:solidFill>
                  <a:schemeClr val="tx1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riseAlimentaire!$L$257:$L$266</c:f>
                <c:numCache>
                  <c:formatCode>General</c:formatCode>
                  <c:ptCount val="10"/>
                  <c:pt idx="0">
                    <c:v>0.172429858457694</c:v>
                  </c:pt>
                  <c:pt idx="1">
                    <c:v>0.102796728101658</c:v>
                  </c:pt>
                  <c:pt idx="2">
                    <c:v>0.107761053468604</c:v>
                  </c:pt>
                  <c:pt idx="3">
                    <c:v>0.114281993987066</c:v>
                  </c:pt>
                  <c:pt idx="4">
                    <c:v>0.140810065916236</c:v>
                  </c:pt>
                  <c:pt idx="5">
                    <c:v>0.104878435939626</c:v>
                  </c:pt>
                  <c:pt idx="6">
                    <c:v>0.0940941747952026</c:v>
                  </c:pt>
                  <c:pt idx="7">
                    <c:v>0.082173527041493</c:v>
                  </c:pt>
                  <c:pt idx="8">
                    <c:v>0.0713374220969791</c:v>
                  </c:pt>
                  <c:pt idx="9">
                    <c:v>0.1410990108109</c:v>
                  </c:pt>
                </c:numCache>
              </c:numRef>
            </c:plus>
            <c:minus>
              <c:numRef>
                <c:f>PriseAlimentaire!$L$257:$L$266</c:f>
                <c:numCache>
                  <c:formatCode>General</c:formatCode>
                  <c:ptCount val="10"/>
                  <c:pt idx="0">
                    <c:v>0.172429858457694</c:v>
                  </c:pt>
                  <c:pt idx="1">
                    <c:v>0.102796728101658</c:v>
                  </c:pt>
                  <c:pt idx="2">
                    <c:v>0.107761053468604</c:v>
                  </c:pt>
                  <c:pt idx="3">
                    <c:v>0.114281993987066</c:v>
                  </c:pt>
                  <c:pt idx="4">
                    <c:v>0.140810065916236</c:v>
                  </c:pt>
                  <c:pt idx="5">
                    <c:v>0.104878435939626</c:v>
                  </c:pt>
                  <c:pt idx="6">
                    <c:v>0.0940941747952026</c:v>
                  </c:pt>
                  <c:pt idx="7">
                    <c:v>0.082173527041493</c:v>
                  </c:pt>
                  <c:pt idx="8">
                    <c:v>0.0713374220969791</c:v>
                  </c:pt>
                  <c:pt idx="9">
                    <c:v>0.1410990108109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numRef>
              <c:f>PriseAlimentaire!$C$257:$C$269</c:f>
              <c:numCache>
                <c:formatCode>General</c:formatCode>
                <c:ptCount val="13"/>
                <c:pt idx="0">
                  <c:v>10.0</c:v>
                </c:pt>
                <c:pt idx="1">
                  <c:v>11.0</c:v>
                </c:pt>
                <c:pt idx="2">
                  <c:v>12.0</c:v>
                </c:pt>
                <c:pt idx="3">
                  <c:v>13.0</c:v>
                </c:pt>
                <c:pt idx="4">
                  <c:v>14.0</c:v>
                </c:pt>
                <c:pt idx="5">
                  <c:v>15.0</c:v>
                </c:pt>
                <c:pt idx="6">
                  <c:v>16.0</c:v>
                </c:pt>
                <c:pt idx="7">
                  <c:v>17.0</c:v>
                </c:pt>
                <c:pt idx="8">
                  <c:v>18.0</c:v>
                </c:pt>
                <c:pt idx="9">
                  <c:v>19.0</c:v>
                </c:pt>
                <c:pt idx="10">
                  <c:v>20.0</c:v>
                </c:pt>
                <c:pt idx="11">
                  <c:v>21.0</c:v>
                </c:pt>
                <c:pt idx="12">
                  <c:v>22.0</c:v>
                </c:pt>
              </c:numCache>
            </c:numRef>
          </c:cat>
          <c:val>
            <c:numRef>
              <c:f>(PriseAlimentaire!$J$257:$J$266,PriseAlimentaire!$J$267)</c:f>
              <c:numCache>
                <c:formatCode>0.00</c:formatCode>
                <c:ptCount val="11"/>
                <c:pt idx="0">
                  <c:v>4.19795918367347</c:v>
                </c:pt>
                <c:pt idx="1">
                  <c:v>4.245481049562683</c:v>
                </c:pt>
                <c:pt idx="2">
                  <c:v>4.199125364431485</c:v>
                </c:pt>
                <c:pt idx="3">
                  <c:v>3.903571428571428</c:v>
                </c:pt>
                <c:pt idx="4">
                  <c:v>4.027551020408164</c:v>
                </c:pt>
                <c:pt idx="5">
                  <c:v>3.966836734693878</c:v>
                </c:pt>
                <c:pt idx="6">
                  <c:v>3.725408163265306</c:v>
                </c:pt>
                <c:pt idx="7">
                  <c:v>3.58</c:v>
                </c:pt>
                <c:pt idx="8">
                  <c:v>3.65</c:v>
                </c:pt>
                <c:pt idx="9">
                  <c:v>3.4</c:v>
                </c:pt>
                <c:pt idx="10" formatCode="General">
                  <c:v>3.222170686456401</c:v>
                </c:pt>
              </c:numCache>
            </c:numRef>
          </c:val>
          <c:smooth val="0"/>
        </c:ser>
        <c:ser>
          <c:idx val="2"/>
          <c:order val="3"/>
          <c:tx>
            <c:v>WL4</c:v>
          </c:tx>
          <c:spPr>
            <a:ln w="19050">
              <a:solidFill>
                <a:schemeClr val="tx1"/>
              </a:solidFill>
              <a:prstDash val="lgDash"/>
            </a:ln>
          </c:spPr>
          <c:marker>
            <c:symbol val="triangle"/>
            <c:size val="5"/>
            <c:spPr>
              <a:solidFill>
                <a:schemeClr val="tx1"/>
              </a:solidFill>
              <a:ln>
                <a:solidFill>
                  <a:schemeClr val="tx1"/>
                </a:solidFill>
                <a:prstDash val="solid"/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PriseAlimentaire!$O$257:$O$269</c:f>
                <c:numCache>
                  <c:formatCode>General</c:formatCode>
                  <c:ptCount val="13"/>
                  <c:pt idx="0">
                    <c:v>0.11228817965775</c:v>
                  </c:pt>
                  <c:pt idx="1">
                    <c:v>0.0754009362841757</c:v>
                  </c:pt>
                  <c:pt idx="2">
                    <c:v>0.0674165155597767</c:v>
                  </c:pt>
                  <c:pt idx="3">
                    <c:v>0.0806574401851816</c:v>
                  </c:pt>
                  <c:pt idx="4">
                    <c:v>0.092510697814098</c:v>
                  </c:pt>
                  <c:pt idx="5">
                    <c:v>0.0693908062554453</c:v>
                  </c:pt>
                  <c:pt idx="6">
                    <c:v>0.0747488274140661</c:v>
                  </c:pt>
                  <c:pt idx="7">
                    <c:v>0.199273487822066</c:v>
                  </c:pt>
                  <c:pt idx="8">
                    <c:v>0.295343872729583</c:v>
                  </c:pt>
                  <c:pt idx="9">
                    <c:v>0.108579051286655</c:v>
                  </c:pt>
                  <c:pt idx="10">
                    <c:v>0.123396766942083</c:v>
                  </c:pt>
                  <c:pt idx="11">
                    <c:v>0.189538584599711</c:v>
                  </c:pt>
                  <c:pt idx="12">
                    <c:v>0.0948769504344122</c:v>
                  </c:pt>
                </c:numCache>
              </c:numRef>
            </c:plus>
            <c:minus>
              <c:numRef>
                <c:f>PriseAlimentaire!$O$257:$O$269</c:f>
                <c:numCache>
                  <c:formatCode>General</c:formatCode>
                  <c:ptCount val="13"/>
                  <c:pt idx="0">
                    <c:v>0.11228817965775</c:v>
                  </c:pt>
                  <c:pt idx="1">
                    <c:v>0.0754009362841757</c:v>
                  </c:pt>
                  <c:pt idx="2">
                    <c:v>0.0674165155597767</c:v>
                  </c:pt>
                  <c:pt idx="3">
                    <c:v>0.0806574401851816</c:v>
                  </c:pt>
                  <c:pt idx="4">
                    <c:v>0.092510697814098</c:v>
                  </c:pt>
                  <c:pt idx="5">
                    <c:v>0.0693908062554453</c:v>
                  </c:pt>
                  <c:pt idx="6">
                    <c:v>0.0747488274140661</c:v>
                  </c:pt>
                  <c:pt idx="7">
                    <c:v>0.199273487822066</c:v>
                  </c:pt>
                  <c:pt idx="8">
                    <c:v>0.295343872729583</c:v>
                  </c:pt>
                  <c:pt idx="9">
                    <c:v>0.108579051286655</c:v>
                  </c:pt>
                  <c:pt idx="10">
                    <c:v>0.123396766942083</c:v>
                  </c:pt>
                  <c:pt idx="11">
                    <c:v>0.189538584599711</c:v>
                  </c:pt>
                  <c:pt idx="12">
                    <c:v>0.0948769504344122</c:v>
                  </c:pt>
                </c:numCache>
              </c:numRef>
            </c:min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numRef>
              <c:f>PriseAlimentaire!$C$257:$C$269</c:f>
              <c:numCache>
                <c:formatCode>General</c:formatCode>
                <c:ptCount val="13"/>
                <c:pt idx="0">
                  <c:v>10.0</c:v>
                </c:pt>
                <c:pt idx="1">
                  <c:v>11.0</c:v>
                </c:pt>
                <c:pt idx="2">
                  <c:v>12.0</c:v>
                </c:pt>
                <c:pt idx="3">
                  <c:v>13.0</c:v>
                </c:pt>
                <c:pt idx="4">
                  <c:v>14.0</c:v>
                </c:pt>
                <c:pt idx="5">
                  <c:v>15.0</c:v>
                </c:pt>
                <c:pt idx="6">
                  <c:v>16.0</c:v>
                </c:pt>
                <c:pt idx="7">
                  <c:v>17.0</c:v>
                </c:pt>
                <c:pt idx="8">
                  <c:v>18.0</c:v>
                </c:pt>
                <c:pt idx="9">
                  <c:v>19.0</c:v>
                </c:pt>
                <c:pt idx="10">
                  <c:v>20.0</c:v>
                </c:pt>
                <c:pt idx="11">
                  <c:v>21.0</c:v>
                </c:pt>
                <c:pt idx="12">
                  <c:v>22.0</c:v>
                </c:pt>
              </c:numCache>
            </c:numRef>
          </c:cat>
          <c:val>
            <c:numRef>
              <c:f>PriseAlimentaire!$M$257:$M$269</c:f>
              <c:numCache>
                <c:formatCode>0.00</c:formatCode>
                <c:ptCount val="13"/>
                <c:pt idx="0">
                  <c:v>4.555102040816327</c:v>
                </c:pt>
                <c:pt idx="1">
                  <c:v>4.490962099125365</c:v>
                </c:pt>
                <c:pt idx="2">
                  <c:v>4.272011661807579</c:v>
                </c:pt>
                <c:pt idx="3">
                  <c:v>4.062244897959182</c:v>
                </c:pt>
                <c:pt idx="4">
                  <c:v>4.205918367346938</c:v>
                </c:pt>
                <c:pt idx="5">
                  <c:v>4.101734693877551</c:v>
                </c:pt>
                <c:pt idx="6">
                  <c:v>3.837448979591836</c:v>
                </c:pt>
                <c:pt idx="7">
                  <c:v>3.347755102040816</c:v>
                </c:pt>
                <c:pt idx="8">
                  <c:v>3.694155844155844</c:v>
                </c:pt>
                <c:pt idx="9">
                  <c:v>3.445878611184733</c:v>
                </c:pt>
                <c:pt idx="10">
                  <c:v>3.398833819241982</c:v>
                </c:pt>
                <c:pt idx="11">
                  <c:v>3.104591836734694</c:v>
                </c:pt>
                <c:pt idx="12">
                  <c:v>3.25648809523809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146731304"/>
        <c:axId val="-2146725528"/>
      </c:lineChart>
      <c:catAx>
        <c:axId val="-214673130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fr-FR"/>
                  <a:t>Age (week)</a:t>
                </a:r>
              </a:p>
            </c:rich>
          </c:tx>
          <c:layout>
            <c:manualLayout>
              <c:xMode val="edge"/>
              <c:yMode val="edge"/>
              <c:x val="0.454202410474207"/>
              <c:y val="0.92820381644458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 w="3175">
            <a:solidFill>
              <a:schemeClr val="tx1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fr-FR"/>
          </a:p>
        </c:txPr>
        <c:crossAx val="-2146725528"/>
        <c:crosses val="autoZero"/>
        <c:auto val="1"/>
        <c:lblAlgn val="ctr"/>
        <c:lblOffset val="100"/>
        <c:noMultiLvlLbl val="0"/>
      </c:catAx>
      <c:valAx>
        <c:axId val="-2146725528"/>
        <c:scaling>
          <c:orientation val="minMax"/>
          <c:max val="5.0"/>
          <c:min val="2.0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fr-FR" dirty="0"/>
                  <a:t>Food </a:t>
                </a:r>
                <a:r>
                  <a:rPr lang="fr-FR" dirty="0" err="1"/>
                  <a:t>intake</a:t>
                </a:r>
                <a:r>
                  <a:rPr lang="fr-FR" dirty="0"/>
                  <a:t> (g/</a:t>
                </a:r>
                <a:r>
                  <a:rPr lang="fr-FR" dirty="0" err="1"/>
                  <a:t>day</a:t>
                </a:r>
                <a:r>
                  <a:rPr lang="fr-FR" dirty="0"/>
                  <a:t>)</a:t>
                </a:r>
              </a:p>
            </c:rich>
          </c:tx>
          <c:layout>
            <c:manualLayout>
              <c:xMode val="edge"/>
              <c:yMode val="edge"/>
              <c:x val="0.0378251649090571"/>
              <c:y val="0.287656511940656"/>
            </c:manualLayout>
          </c:layout>
          <c:overlay val="0"/>
          <c:spPr>
            <a:noFill/>
            <a:ln w="25400">
              <a:noFill/>
            </a:ln>
          </c:spPr>
        </c:title>
        <c:numFmt formatCode="0" sourceLinked="0"/>
        <c:majorTickMark val="out"/>
        <c:minorTickMark val="none"/>
        <c:tickLblPos val="nextTo"/>
        <c:spPr>
          <a:ln w="3175">
            <a:solidFill>
              <a:schemeClr val="tx1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fr-FR"/>
          </a:p>
        </c:txPr>
        <c:crossAx val="-2146731304"/>
        <c:crosses val="autoZero"/>
        <c:crossBetween val="between"/>
        <c:majorUnit val="1.0"/>
        <c:minorUnit val="0.5"/>
      </c:valAx>
      <c:spPr>
        <a:solidFill>
          <a:srgbClr val="FFFFFF"/>
        </a:solidFill>
        <a:ln w="25400">
          <a:noFill/>
        </a:ln>
      </c:spPr>
    </c:plotArea>
    <c:legend>
      <c:legendPos val="r"/>
      <c:layout>
        <c:manualLayout>
          <c:xMode val="edge"/>
          <c:yMode val="edge"/>
          <c:x val="0.767791324147435"/>
          <c:y val="0.0565485309566013"/>
          <c:w val="0.0998850534358142"/>
          <c:h val="0.20310793101119"/>
        </c:manualLayout>
      </c:layout>
      <c:overlay val="0"/>
      <c:spPr>
        <a:noFill/>
        <a:ln w="25400">
          <a:noFill/>
        </a:ln>
      </c:spPr>
    </c:legend>
    <c:plotVisOnly val="1"/>
    <c:dispBlanksAs val="gap"/>
    <c:showDLblsOverMax val="0"/>
  </c:chart>
  <c:spPr>
    <a:solidFill>
      <a:srgbClr val="FFFFFF"/>
    </a:solidFill>
    <a:ln w="3175">
      <a:noFill/>
      <a:prstDash val="solid"/>
    </a:ln>
  </c:spPr>
  <c:txPr>
    <a:bodyPr/>
    <a:lstStyle/>
    <a:p>
      <a:pPr>
        <a:defRPr sz="1400" b="0" i="0" u="none" strike="noStrike" baseline="0">
          <a:solidFill>
            <a:srgbClr val="000000"/>
          </a:solidFill>
          <a:latin typeface="Calibri"/>
          <a:ea typeface="Calibri"/>
          <a:cs typeface="Calibri"/>
        </a:defRPr>
      </a:pPr>
      <a:endParaRPr lang="fr-FR"/>
    </a:p>
  </c:txPr>
  <c:externalData r:id="rId1">
    <c:autoUpdate val="0"/>
  </c:externalData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96613327349338"/>
          <c:y val="0.0222092889631933"/>
          <c:w val="0.589855363582115"/>
          <c:h val="0.85071649843132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Hist Muscle'!$A$3</c:f>
              <c:strCache>
                <c:ptCount val="1"/>
                <c:pt idx="0">
                  <c:v>Befor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('Hist Muscle'!$U$3;'Hist Muscle'!$W$3)</c:f>
                <c:numCache>
                  <c:formatCode>General</c:formatCode>
                  <c:ptCount val="2"/>
                  <c:pt idx="0">
                    <c:v>4.17331979009404</c:v>
                  </c:pt>
                  <c:pt idx="1">
                    <c:v>4.1515453721361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('Hist Muscle'!$T$2;'Hist Muscle'!$V$2)</c:f>
              <c:strCache>
                <c:ptCount val="2"/>
                <c:pt idx="0">
                  <c:v>Toward                 inactivity</c:v>
                </c:pt>
                <c:pt idx="1">
                  <c:v>Toward                            Activity</c:v>
                </c:pt>
              </c:strCache>
            </c:strRef>
          </c:cat>
          <c:val>
            <c:numRef>
              <c:f>('Hist Muscle'!$T$3;'Hist Muscle'!$V$3)</c:f>
              <c:numCache>
                <c:formatCode>General</c:formatCode>
                <c:ptCount val="2"/>
                <c:pt idx="0">
                  <c:v>34.1842157122222</c:v>
                </c:pt>
                <c:pt idx="1">
                  <c:v>38.07314679571429</c:v>
                </c:pt>
              </c:numCache>
            </c:numRef>
          </c:val>
        </c:ser>
        <c:ser>
          <c:idx val="1"/>
          <c:order val="1"/>
          <c:tx>
            <c:strRef>
              <c:f>'Hist Muscle'!$A$4</c:f>
              <c:strCache>
                <c:ptCount val="1"/>
                <c:pt idx="0">
                  <c:v>After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1"/>
            <c:invertIfNegative val="0"/>
            <c:bubble3D val="0"/>
            <c:spPr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('Hist Muscle'!$U$4;'Hist Muscle'!$W$4)</c:f>
                <c:numCache>
                  <c:formatCode>General</c:formatCode>
                  <c:ptCount val="2"/>
                  <c:pt idx="0">
                    <c:v>7.46305747172818</c:v>
                  </c:pt>
                  <c:pt idx="1">
                    <c:v>3.627342933151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</c:errBars>
          <c:cat>
            <c:strRef>
              <c:f>('Hist Muscle'!$T$2;'Hist Muscle'!$V$2)</c:f>
              <c:strCache>
                <c:ptCount val="2"/>
                <c:pt idx="0">
                  <c:v>Toward                 inactivity</c:v>
                </c:pt>
                <c:pt idx="1">
                  <c:v>Toward                            Activity</c:v>
                </c:pt>
              </c:strCache>
            </c:strRef>
          </c:cat>
          <c:val>
            <c:numRef>
              <c:f>('Hist Muscle'!$T$4;'Hist Muscle'!$V$4)</c:f>
              <c:numCache>
                <c:formatCode>General</c:formatCode>
                <c:ptCount val="2"/>
                <c:pt idx="0">
                  <c:v>38.80729584571429</c:v>
                </c:pt>
                <c:pt idx="1">
                  <c:v>30.660593217142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28066184"/>
        <c:axId val="2128069560"/>
      </c:barChart>
      <c:catAx>
        <c:axId val="2128066184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b="1"/>
            </a:pPr>
            <a:endParaRPr lang="fr-FR"/>
          </a:p>
        </c:txPr>
        <c:crossAx val="2128069560"/>
        <c:crosses val="autoZero"/>
        <c:auto val="1"/>
        <c:lblAlgn val="ctr"/>
        <c:lblOffset val="100"/>
        <c:noMultiLvlLbl val="0"/>
      </c:catAx>
      <c:valAx>
        <c:axId val="2128069560"/>
        <c:scaling>
          <c:orientation val="minMax"/>
          <c:max val="60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128066184"/>
        <c:crosses val="autoZero"/>
        <c:crossBetween val="between"/>
        <c:minorUnit val="2.0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61196</cdr:x>
      <cdr:y>0.92823</cdr:y>
    </cdr:from>
    <cdr:to>
      <cdr:x>0.71404</cdr:x>
      <cdr:y>0.98037</cdr:y>
    </cdr:to>
    <cdr:sp macro="" textlink="">
      <cdr:nvSpPr>
        <cdr:cNvPr id="3" name="ZoneTexte 2"/>
        <cdr:cNvSpPr txBox="1"/>
      </cdr:nvSpPr>
      <cdr:spPr>
        <a:xfrm xmlns:a="http://schemas.openxmlformats.org/drawingml/2006/main">
          <a:off x="4566815" y="4383635"/>
          <a:ext cx="761747" cy="246221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solidFill>
            <a:schemeClr val="bg1">
              <a:lumMod val="50000"/>
            </a:schemeClr>
          </a:solidFill>
        </a:ln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fr-FR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fr-FR" sz="1000" dirty="0" smtClean="0"/>
            <a:t>Wheel </a:t>
          </a:r>
          <a:r>
            <a:rPr lang="fr-FR" sz="1000" dirty="0" err="1" smtClean="0"/>
            <a:t>lock</a:t>
          </a:r>
          <a:endParaRPr lang="fr-FR" sz="1000" dirty="0"/>
        </a:p>
      </cdr:txBody>
    </cdr:sp>
  </cdr:relSizeAnchor>
  <cdr:relSizeAnchor xmlns:cdr="http://schemas.openxmlformats.org/drawingml/2006/chartDrawing">
    <cdr:from>
      <cdr:x>0.66424</cdr:x>
      <cdr:y>0.11269</cdr:y>
    </cdr:from>
    <cdr:to>
      <cdr:x>0.66424</cdr:x>
      <cdr:y>0.92933</cdr:y>
    </cdr:to>
    <cdr:cxnSp macro="">
      <cdr:nvCxnSpPr>
        <cdr:cNvPr id="2" name="Connecteur droit 1"/>
        <cdr:cNvCxnSpPr/>
      </cdr:nvCxnSpPr>
      <cdr:spPr>
        <a:xfrm xmlns:a="http://schemas.openxmlformats.org/drawingml/2006/main">
          <a:off x="4956958" y="532207"/>
          <a:ext cx="0" cy="385661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chemeClr val="bg1">
              <a:lumMod val="50000"/>
            </a:schemeClr>
          </a:solidFill>
        </a:ln>
        <a:effectLst xmlns:a="http://schemas.openxmlformats.org/drawingml/2006/main"/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B0A06-4D8E-2946-8BE3-BB6D24D523B4}" type="datetimeFigureOut">
              <a:rPr lang="fr-FR" smtClean="0"/>
              <a:t>15/07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83E67-8F3D-D94D-A9AC-570A9B68C81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15380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B0A06-4D8E-2946-8BE3-BB6D24D523B4}" type="datetimeFigureOut">
              <a:rPr lang="fr-FR" smtClean="0"/>
              <a:t>15/07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83E67-8F3D-D94D-A9AC-570A9B68C81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395585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B0A06-4D8E-2946-8BE3-BB6D24D523B4}" type="datetimeFigureOut">
              <a:rPr lang="fr-FR" smtClean="0"/>
              <a:t>15/07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83E67-8F3D-D94D-A9AC-570A9B68C81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494935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B0A06-4D8E-2946-8BE3-BB6D24D523B4}" type="datetimeFigureOut">
              <a:rPr lang="fr-FR" smtClean="0"/>
              <a:t>15/07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83E67-8F3D-D94D-A9AC-570A9B68C81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804037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B0A06-4D8E-2946-8BE3-BB6D24D523B4}" type="datetimeFigureOut">
              <a:rPr lang="fr-FR" smtClean="0"/>
              <a:t>15/07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83E67-8F3D-D94D-A9AC-570A9B68C81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505901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B0A06-4D8E-2946-8BE3-BB6D24D523B4}" type="datetimeFigureOut">
              <a:rPr lang="fr-FR" smtClean="0"/>
              <a:t>15/07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83E67-8F3D-D94D-A9AC-570A9B68C81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86691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B0A06-4D8E-2946-8BE3-BB6D24D523B4}" type="datetimeFigureOut">
              <a:rPr lang="fr-FR" smtClean="0"/>
              <a:t>15/07/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83E67-8F3D-D94D-A9AC-570A9B68C81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867950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B0A06-4D8E-2946-8BE3-BB6D24D523B4}" type="datetimeFigureOut">
              <a:rPr lang="fr-FR" smtClean="0"/>
              <a:t>15/07/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83E67-8F3D-D94D-A9AC-570A9B68C81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245261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B0A06-4D8E-2946-8BE3-BB6D24D523B4}" type="datetimeFigureOut">
              <a:rPr lang="fr-FR" smtClean="0"/>
              <a:t>15/07/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83E67-8F3D-D94D-A9AC-570A9B68C81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763882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B0A06-4D8E-2946-8BE3-BB6D24D523B4}" type="datetimeFigureOut">
              <a:rPr lang="fr-FR" smtClean="0"/>
              <a:t>15/07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83E67-8F3D-D94D-A9AC-570A9B68C81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56394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AB0A06-4D8E-2946-8BE3-BB6D24D523B4}" type="datetimeFigureOut">
              <a:rPr lang="fr-FR" smtClean="0"/>
              <a:t>15/07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583E67-8F3D-D94D-A9AC-570A9B68C81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7447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AB0A06-4D8E-2946-8BE3-BB6D24D523B4}" type="datetimeFigureOut">
              <a:rPr lang="fr-FR" smtClean="0"/>
              <a:t>15/07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583E67-8F3D-D94D-A9AC-570A9B68C81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56589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3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0" name="Graphique 2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56211358"/>
              </p:ext>
            </p:extLst>
          </p:nvPr>
        </p:nvGraphicFramePr>
        <p:xfrm>
          <a:off x="676729" y="76591"/>
          <a:ext cx="7523843" cy="56805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26" name="Connecteur droit 25"/>
          <p:cNvCxnSpPr/>
          <p:nvPr/>
        </p:nvCxnSpPr>
        <p:spPr>
          <a:xfrm>
            <a:off x="5657059" y="997861"/>
            <a:ext cx="0" cy="4340549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ZoneTexte 26"/>
          <p:cNvSpPr txBox="1"/>
          <p:nvPr/>
        </p:nvSpPr>
        <p:spPr>
          <a:xfrm>
            <a:off x="5276185" y="5342820"/>
            <a:ext cx="761747" cy="246221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txBody>
          <a:bodyPr wrap="none" rtlCol="0">
            <a:spAutoFit/>
          </a:bodyPr>
          <a:lstStyle/>
          <a:p>
            <a:r>
              <a:rPr lang="fr-FR" sz="1000" dirty="0" smtClean="0"/>
              <a:t>Wheel </a:t>
            </a:r>
            <a:r>
              <a:rPr lang="fr-FR" sz="1000" dirty="0" err="1" smtClean="0"/>
              <a:t>lock</a:t>
            </a:r>
            <a:endParaRPr lang="fr-FR" sz="1000" dirty="0"/>
          </a:p>
        </p:txBody>
      </p:sp>
      <p:sp>
        <p:nvSpPr>
          <p:cNvPr id="29" name="ZoneTexte 28"/>
          <p:cNvSpPr txBox="1"/>
          <p:nvPr/>
        </p:nvSpPr>
        <p:spPr>
          <a:xfrm>
            <a:off x="1233836" y="5868369"/>
            <a:ext cx="73504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Supplementary Figure </a:t>
            </a:r>
            <a:r>
              <a:rPr lang="en-US" sz="1200" dirty="0" smtClean="0"/>
              <a:t>S1 </a:t>
            </a:r>
            <a:r>
              <a:rPr lang="en-US" sz="1200" dirty="0" smtClean="0"/>
              <a:t>: Mouse body weight for the SED, EX WL2 and WL4 groups during the protocol. Wheels were locked for WL2 and WL4 after 8 weeks of free access. WL2 mice were sacrificed at age of 20 weeks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9613859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Graphique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94269088"/>
              </p:ext>
            </p:extLst>
          </p:nvPr>
        </p:nvGraphicFramePr>
        <p:xfrm>
          <a:off x="592938" y="667483"/>
          <a:ext cx="7787419" cy="51174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6" name="Connecteur droit 5"/>
          <p:cNvCxnSpPr/>
          <p:nvPr/>
        </p:nvCxnSpPr>
        <p:spPr>
          <a:xfrm>
            <a:off x="5796109" y="1020813"/>
            <a:ext cx="0" cy="4340549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ZoneTexte 6"/>
          <p:cNvSpPr txBox="1"/>
          <p:nvPr/>
        </p:nvSpPr>
        <p:spPr>
          <a:xfrm>
            <a:off x="5415235" y="5365772"/>
            <a:ext cx="761747" cy="246221"/>
          </a:xfrm>
          <a:prstGeom prst="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txBody>
          <a:bodyPr wrap="none" rtlCol="0">
            <a:spAutoFit/>
          </a:bodyPr>
          <a:lstStyle/>
          <a:p>
            <a:r>
              <a:rPr lang="fr-FR" sz="1000" dirty="0" smtClean="0"/>
              <a:t>Wheel </a:t>
            </a:r>
            <a:r>
              <a:rPr lang="fr-FR" sz="1000" dirty="0" err="1" smtClean="0"/>
              <a:t>lock</a:t>
            </a:r>
            <a:endParaRPr lang="fr-FR" sz="1000" dirty="0"/>
          </a:p>
        </p:txBody>
      </p:sp>
      <p:sp>
        <p:nvSpPr>
          <p:cNvPr id="8" name="ZoneTexte 7"/>
          <p:cNvSpPr txBox="1"/>
          <p:nvPr/>
        </p:nvSpPr>
        <p:spPr>
          <a:xfrm>
            <a:off x="1233836" y="5868369"/>
            <a:ext cx="735047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Supplementary Figure </a:t>
            </a:r>
            <a:r>
              <a:rPr lang="en-US" sz="1200" dirty="0" smtClean="0"/>
              <a:t>S2 </a:t>
            </a:r>
            <a:r>
              <a:rPr lang="en-US" sz="1200" dirty="0" smtClean="0"/>
              <a:t>: Mean running distance for the SED, EX WL2 and WL4 groups during the protocol. Wheels were locked for WL2 and WL4 after 8 weeks of free access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5313558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49015812"/>
              </p:ext>
            </p:extLst>
          </p:nvPr>
        </p:nvGraphicFramePr>
        <p:xfrm>
          <a:off x="639651" y="682243"/>
          <a:ext cx="7462598" cy="47225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ZoneTexte 4"/>
          <p:cNvSpPr txBox="1"/>
          <p:nvPr/>
        </p:nvSpPr>
        <p:spPr>
          <a:xfrm>
            <a:off x="1233836" y="5766391"/>
            <a:ext cx="735047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Supplementary Figure </a:t>
            </a:r>
            <a:r>
              <a:rPr lang="en-US" sz="1200" dirty="0" smtClean="0"/>
              <a:t>S3 </a:t>
            </a:r>
            <a:r>
              <a:rPr lang="en-US" sz="1200" dirty="0" smtClean="0"/>
              <a:t>: Food intake for the SED, EX WL2 and WL4 groups during the protocol. Wheels were locked for WL2 and WL4 after 8 weeks of free access. WL2 and WL4 mice spontaneously reduced their food intake after wheel lock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71206485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69756518"/>
              </p:ext>
            </p:extLst>
          </p:nvPr>
        </p:nvGraphicFramePr>
        <p:xfrm>
          <a:off x="2196192" y="858733"/>
          <a:ext cx="3400181" cy="40464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ZoneTexte 7"/>
          <p:cNvSpPr txBox="1"/>
          <p:nvPr/>
        </p:nvSpPr>
        <p:spPr>
          <a:xfrm>
            <a:off x="762002" y="5660571"/>
            <a:ext cx="680257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Supplementary figure </a:t>
            </a:r>
            <a:r>
              <a:rPr lang="en-US" sz="1400" dirty="0" smtClean="0"/>
              <a:t>S4 </a:t>
            </a:r>
            <a:r>
              <a:rPr lang="en-US" sz="1400" dirty="0" smtClean="0"/>
              <a:t>: miR-133a quantification by RT-PCR in the LIPOX protocol. Measurements were in the same conditions and for the same samples as described for miR-148b in figure 2A.</a:t>
            </a:r>
            <a:r>
              <a:rPr lang="en-US" sz="1400" dirty="0" smtClean="0">
                <a:effectLst/>
              </a:rPr>
              <a:t> </a:t>
            </a:r>
            <a:r>
              <a:rPr lang="en-US" sz="1400" dirty="0" smtClean="0"/>
              <a:t> For miR-133a, no significant changes were observed between groups.</a:t>
            </a:r>
            <a:endParaRPr lang="en-US" sz="1400" dirty="0"/>
          </a:p>
        </p:txBody>
      </p:sp>
      <p:sp>
        <p:nvSpPr>
          <p:cNvPr id="9" name="ZoneTexte 8"/>
          <p:cNvSpPr txBox="1"/>
          <p:nvPr/>
        </p:nvSpPr>
        <p:spPr>
          <a:xfrm rot="16200000">
            <a:off x="1801215" y="2625206"/>
            <a:ext cx="18143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 smtClean="0"/>
              <a:t>Muscle miR-133a (AU)</a:t>
            </a:r>
            <a:endParaRPr lang="fr-FR" sz="1400" dirty="0"/>
          </a:p>
        </p:txBody>
      </p:sp>
      <p:sp>
        <p:nvSpPr>
          <p:cNvPr id="10" name="ZoneTexte 9"/>
          <p:cNvSpPr txBox="1"/>
          <p:nvPr/>
        </p:nvSpPr>
        <p:spPr>
          <a:xfrm>
            <a:off x="4283211" y="4339702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 smtClean="0"/>
              <a:t>Before</a:t>
            </a:r>
            <a:endParaRPr lang="fr-FR" sz="800" dirty="0"/>
          </a:p>
        </p:txBody>
      </p:sp>
      <p:sp>
        <p:nvSpPr>
          <p:cNvPr id="11" name="ZoneTexte 10"/>
          <p:cNvSpPr txBox="1"/>
          <p:nvPr/>
        </p:nvSpPr>
        <p:spPr>
          <a:xfrm>
            <a:off x="3727271" y="4348973"/>
            <a:ext cx="4026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 smtClean="0"/>
              <a:t>After</a:t>
            </a:r>
            <a:endParaRPr lang="fr-FR" sz="800" dirty="0"/>
          </a:p>
        </p:txBody>
      </p:sp>
      <p:sp>
        <p:nvSpPr>
          <p:cNvPr id="12" name="ZoneTexte 11"/>
          <p:cNvSpPr txBox="1"/>
          <p:nvPr/>
        </p:nvSpPr>
        <p:spPr>
          <a:xfrm>
            <a:off x="3253719" y="4348973"/>
            <a:ext cx="4667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 smtClean="0"/>
              <a:t>Before</a:t>
            </a:r>
            <a:endParaRPr lang="fr-FR" sz="800" dirty="0"/>
          </a:p>
        </p:txBody>
      </p:sp>
      <p:sp>
        <p:nvSpPr>
          <p:cNvPr id="13" name="ZoneTexte 12"/>
          <p:cNvSpPr txBox="1"/>
          <p:nvPr/>
        </p:nvSpPr>
        <p:spPr>
          <a:xfrm>
            <a:off x="4742558" y="4348973"/>
            <a:ext cx="4026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 smtClean="0"/>
              <a:t>After</a:t>
            </a:r>
            <a:endParaRPr lang="fr-FR" sz="800" dirty="0"/>
          </a:p>
        </p:txBody>
      </p:sp>
    </p:spTree>
    <p:extLst>
      <p:ext uri="{BB962C8B-B14F-4D97-AF65-F5344CB8AC3E}">
        <p14:creationId xmlns:p14="http://schemas.microsoft.com/office/powerpoint/2010/main" val="5678516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3</TotalTime>
  <Words>223</Words>
  <Application>Microsoft Macintosh PowerPoint</Application>
  <PresentationFormat>Présentation à l'écran (4:3)</PresentationFormat>
  <Paragraphs>18</Paragraphs>
  <Slides>4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5" baseType="lpstr">
      <vt:lpstr>Thème Office</vt:lpstr>
      <vt:lpstr>Présentation PowerPoint</vt:lpstr>
      <vt:lpstr>Présentation PowerPoint</vt:lpstr>
      <vt:lpstr>Présentation PowerPoint</vt:lpstr>
      <vt:lpstr>Présentation PowerPoint</vt:lpstr>
    </vt:vector>
  </TitlesOfParts>
  <Company>Laboratoire Carme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tienne Lefai</dc:creator>
  <cp:lastModifiedBy>Etienne Lefai</cp:lastModifiedBy>
  <cp:revision>18</cp:revision>
  <cp:lastPrinted>2016-07-15T09:13:48Z</cp:lastPrinted>
  <dcterms:created xsi:type="dcterms:W3CDTF">2016-07-13T09:35:26Z</dcterms:created>
  <dcterms:modified xsi:type="dcterms:W3CDTF">2016-07-15T09:54:44Z</dcterms:modified>
</cp:coreProperties>
</file>